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61" r:id="rId3"/>
    <p:sldId id="257" r:id="rId4"/>
    <p:sldId id="262" r:id="rId5"/>
    <p:sldId id="258" r:id="rId6"/>
    <p:sldId id="263" r:id="rId7"/>
    <p:sldId id="260" r:id="rId8"/>
    <p:sldId id="264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04" userDrawn="1">
          <p15:clr>
            <a:srgbClr val="A4A3A4"/>
          </p15:clr>
        </p15:guide>
        <p15:guide id="2" pos="14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380" autoAdjust="0"/>
    <p:restoredTop sz="94660"/>
  </p:normalViewPr>
  <p:slideViewPr>
    <p:cSldViewPr snapToGrid="0">
      <p:cViewPr>
        <p:scale>
          <a:sx n="111" d="100"/>
          <a:sy n="111" d="100"/>
        </p:scale>
        <p:origin x="6288" y="696"/>
      </p:cViewPr>
      <p:guideLst>
        <p:guide orient="horz" pos="3504"/>
        <p:guide pos="14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1B10D-403C-4A94-BA21-A9E5DF7E7ECF}" type="datetimeFigureOut">
              <a:rPr lang="en-US" smtClean="0"/>
              <a:t>10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88B92-FAEB-4EFE-9654-649FBF510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454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1B10D-403C-4A94-BA21-A9E5DF7E7ECF}" type="datetimeFigureOut">
              <a:rPr lang="en-US" smtClean="0"/>
              <a:t>10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88B92-FAEB-4EFE-9654-649FBF510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167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1B10D-403C-4A94-BA21-A9E5DF7E7ECF}" type="datetimeFigureOut">
              <a:rPr lang="en-US" smtClean="0"/>
              <a:t>10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88B92-FAEB-4EFE-9654-649FBF510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136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1B10D-403C-4A94-BA21-A9E5DF7E7ECF}" type="datetimeFigureOut">
              <a:rPr lang="en-US" smtClean="0"/>
              <a:t>10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88B92-FAEB-4EFE-9654-649FBF510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681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1B10D-403C-4A94-BA21-A9E5DF7E7ECF}" type="datetimeFigureOut">
              <a:rPr lang="en-US" smtClean="0"/>
              <a:t>10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88B92-FAEB-4EFE-9654-649FBF510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205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1B10D-403C-4A94-BA21-A9E5DF7E7ECF}" type="datetimeFigureOut">
              <a:rPr lang="en-US" smtClean="0"/>
              <a:t>10/1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88B92-FAEB-4EFE-9654-649FBF510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7272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1B10D-403C-4A94-BA21-A9E5DF7E7ECF}" type="datetimeFigureOut">
              <a:rPr lang="en-US" smtClean="0"/>
              <a:t>10/1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88B92-FAEB-4EFE-9654-649FBF510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268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1B10D-403C-4A94-BA21-A9E5DF7E7ECF}" type="datetimeFigureOut">
              <a:rPr lang="en-US" smtClean="0"/>
              <a:t>10/1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88B92-FAEB-4EFE-9654-649FBF510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0684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1B10D-403C-4A94-BA21-A9E5DF7E7ECF}" type="datetimeFigureOut">
              <a:rPr lang="en-US" smtClean="0"/>
              <a:t>10/1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88B92-FAEB-4EFE-9654-649FBF510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367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1B10D-403C-4A94-BA21-A9E5DF7E7ECF}" type="datetimeFigureOut">
              <a:rPr lang="en-US" smtClean="0"/>
              <a:t>10/1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88B92-FAEB-4EFE-9654-649FBF510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5424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1B10D-403C-4A94-BA21-A9E5DF7E7ECF}" type="datetimeFigureOut">
              <a:rPr lang="en-US" smtClean="0"/>
              <a:t>10/1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88B92-FAEB-4EFE-9654-649FBF510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0503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A1B10D-403C-4A94-BA21-A9E5DF7E7ECF}" type="datetimeFigureOut">
              <a:rPr lang="en-US" smtClean="0"/>
              <a:t>10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B88B92-FAEB-4EFE-9654-649FBF510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190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2"/>
          <a:srcRect l="3821"/>
          <a:stretch/>
        </p:blipFill>
        <p:spPr>
          <a:xfrm>
            <a:off x="981776" y="4575726"/>
            <a:ext cx="2429221" cy="2391786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100756" y="-8865"/>
            <a:ext cx="9104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/>
              <a:t>Figure 3C 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1290" y="1091022"/>
            <a:ext cx="2402246" cy="2400174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931289" y="2867587"/>
            <a:ext cx="2402246" cy="3698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grpSp>
        <p:nvGrpSpPr>
          <p:cNvPr id="8" name="Group 7"/>
          <p:cNvGrpSpPr/>
          <p:nvPr/>
        </p:nvGrpSpPr>
        <p:grpSpPr>
          <a:xfrm>
            <a:off x="139813" y="1319348"/>
            <a:ext cx="804278" cy="1732914"/>
            <a:chOff x="136678" y="1519206"/>
            <a:chExt cx="804278" cy="1732914"/>
          </a:xfrm>
        </p:grpSpPr>
        <p:sp>
          <p:nvSpPr>
            <p:cNvPr id="45" name="TextBox 44"/>
            <p:cNvSpPr txBox="1"/>
            <p:nvPr/>
          </p:nvSpPr>
          <p:spPr>
            <a:xfrm>
              <a:off x="136678" y="2255257"/>
              <a:ext cx="5870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SREBP2</a:t>
              </a:r>
            </a:p>
          </p:txBody>
        </p:sp>
        <p:sp>
          <p:nvSpPr>
            <p:cNvPr id="46" name="Left Bracket 45"/>
            <p:cNvSpPr/>
            <p:nvPr/>
          </p:nvSpPr>
          <p:spPr>
            <a:xfrm>
              <a:off x="669747" y="1653445"/>
              <a:ext cx="62554" cy="1517434"/>
            </a:xfrm>
            <a:prstGeom prst="leftBracket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687360" y="1519206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p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87360" y="3005899"/>
              <a:ext cx="2375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c</a:t>
              </a: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1141063" y="875625"/>
            <a:ext cx="2160243" cy="246221"/>
            <a:chOff x="1134919" y="392764"/>
            <a:chExt cx="1874553" cy="394536"/>
          </a:xfrm>
        </p:grpSpPr>
        <p:sp>
          <p:nvSpPr>
            <p:cNvPr id="43" name="TextBox 42"/>
            <p:cNvSpPr txBox="1"/>
            <p:nvPr/>
          </p:nvSpPr>
          <p:spPr>
            <a:xfrm>
              <a:off x="1134919" y="392764"/>
              <a:ext cx="882177" cy="3945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0         2            4 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048805" y="392764"/>
              <a:ext cx="960667" cy="394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0          2           4 </a:t>
              </a:r>
            </a:p>
          </p:txBody>
        </p:sp>
      </p:grpSp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09753" y="1055652"/>
            <a:ext cx="2407369" cy="2400174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3714876" y="2839469"/>
            <a:ext cx="2402246" cy="3154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12" name="TextBox 11"/>
          <p:cNvSpPr txBox="1"/>
          <p:nvPr/>
        </p:nvSpPr>
        <p:spPr>
          <a:xfrm>
            <a:off x="6067157" y="2921407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U2AF65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3822792" y="815595"/>
            <a:ext cx="2218862" cy="258478"/>
            <a:chOff x="1134919" y="392765"/>
            <a:chExt cx="2218862" cy="258478"/>
          </a:xfrm>
        </p:grpSpPr>
        <p:sp>
          <p:nvSpPr>
            <p:cNvPr id="36" name="TextBox 35"/>
            <p:cNvSpPr txBox="1"/>
            <p:nvPr/>
          </p:nvSpPr>
          <p:spPr>
            <a:xfrm>
              <a:off x="1134919" y="392765"/>
              <a:ext cx="11756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 0           2            4 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279448" y="405022"/>
              <a:ext cx="10743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0           2            4 </a:t>
              </a:r>
            </a:p>
          </p:txBody>
        </p:sp>
      </p:grpSp>
      <p:cxnSp>
        <p:nvCxnSpPr>
          <p:cNvPr id="15" name="Straight Connector 14"/>
          <p:cNvCxnSpPr/>
          <p:nvPr/>
        </p:nvCxnSpPr>
        <p:spPr>
          <a:xfrm>
            <a:off x="1129729" y="815594"/>
            <a:ext cx="87760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2263788" y="828526"/>
            <a:ext cx="87760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913931" y="826745"/>
            <a:ext cx="87760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5035633" y="839677"/>
            <a:ext cx="87760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1203882" y="501171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5% CO</a:t>
            </a:r>
            <a:r>
              <a:rPr lang="en-US" sz="1000" b="1" baseline="-25000" dirty="0"/>
              <a:t>2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302417" y="517140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1% CO</a:t>
            </a:r>
            <a:r>
              <a:rPr lang="en-US" sz="1000" b="1" baseline="-25000" dirty="0"/>
              <a:t>2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048298" y="550710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5% CO</a:t>
            </a:r>
            <a:r>
              <a:rPr lang="en-US" sz="1000" b="1" baseline="-25000" dirty="0"/>
              <a:t>2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217423" y="553795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1% CO</a:t>
            </a:r>
            <a:r>
              <a:rPr lang="en-US" sz="1000" b="1" baseline="-25000" dirty="0"/>
              <a:t>2</a:t>
            </a:r>
          </a:p>
        </p:txBody>
      </p:sp>
      <p:grpSp>
        <p:nvGrpSpPr>
          <p:cNvPr id="24" name="Group 23"/>
          <p:cNvGrpSpPr/>
          <p:nvPr/>
        </p:nvGrpSpPr>
        <p:grpSpPr>
          <a:xfrm>
            <a:off x="834286" y="1033793"/>
            <a:ext cx="490663" cy="2416452"/>
            <a:chOff x="6001504" y="1177121"/>
            <a:chExt cx="490663" cy="2416452"/>
          </a:xfrm>
        </p:grpSpPr>
        <p:sp>
          <p:nvSpPr>
            <p:cNvPr id="31" name="TextBox 30"/>
            <p:cNvSpPr txBox="1"/>
            <p:nvPr/>
          </p:nvSpPr>
          <p:spPr>
            <a:xfrm>
              <a:off x="6008760" y="117712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70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010545" y="1550682"/>
              <a:ext cx="4676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30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001504" y="2144750"/>
              <a:ext cx="4676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00</a:t>
              </a:r>
              <a:endParaRPr lang="en-US" sz="1000" b="1" dirty="0">
                <a:solidFill>
                  <a:srgbClr val="FFFF00"/>
                </a:solidFill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024495" y="2776867"/>
              <a:ext cx="4676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70</a:t>
              </a:r>
              <a:endParaRPr lang="en-US" sz="900" b="1" dirty="0">
                <a:solidFill>
                  <a:srgbClr val="FFFF00"/>
                </a:solidFill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009418" y="3378129"/>
              <a:ext cx="4676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55</a:t>
              </a:r>
              <a:endParaRPr lang="en-US" sz="1000" b="1" dirty="0">
                <a:solidFill>
                  <a:srgbClr val="FFFF00"/>
                </a:solidFill>
              </a:endParaRP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3617372" y="1001135"/>
            <a:ext cx="495429" cy="2459269"/>
            <a:chOff x="5981661" y="1188323"/>
            <a:chExt cx="495429" cy="2459269"/>
          </a:xfrm>
        </p:grpSpPr>
        <p:sp>
          <p:nvSpPr>
            <p:cNvPr id="26" name="TextBox 25"/>
            <p:cNvSpPr txBox="1"/>
            <p:nvPr/>
          </p:nvSpPr>
          <p:spPr>
            <a:xfrm>
              <a:off x="5992747" y="118832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70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991744" y="1558657"/>
              <a:ext cx="4676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30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981661" y="2235124"/>
              <a:ext cx="4676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00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009418" y="2859701"/>
              <a:ext cx="4676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70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009418" y="3432148"/>
              <a:ext cx="4676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55</a:t>
              </a: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333936" y="853432"/>
            <a:ext cx="6703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Time (h)</a:t>
            </a:r>
          </a:p>
        </p:txBody>
      </p:sp>
      <p:sp>
        <p:nvSpPr>
          <p:cNvPr id="108" name="Rectangle 107"/>
          <p:cNvSpPr/>
          <p:nvPr/>
        </p:nvSpPr>
        <p:spPr>
          <a:xfrm>
            <a:off x="991401" y="4795762"/>
            <a:ext cx="2390259" cy="4411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grpSp>
        <p:nvGrpSpPr>
          <p:cNvPr id="110" name="Group 109"/>
          <p:cNvGrpSpPr/>
          <p:nvPr/>
        </p:nvGrpSpPr>
        <p:grpSpPr>
          <a:xfrm>
            <a:off x="126056" y="4795762"/>
            <a:ext cx="804278" cy="1893796"/>
            <a:chOff x="136678" y="1519206"/>
            <a:chExt cx="804278" cy="1732914"/>
          </a:xfrm>
        </p:grpSpPr>
        <p:sp>
          <p:nvSpPr>
            <p:cNvPr id="111" name="TextBox 110"/>
            <p:cNvSpPr txBox="1"/>
            <p:nvPr/>
          </p:nvSpPr>
          <p:spPr>
            <a:xfrm>
              <a:off x="136678" y="2255257"/>
              <a:ext cx="5870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SREBP2</a:t>
              </a:r>
            </a:p>
          </p:txBody>
        </p:sp>
        <p:sp>
          <p:nvSpPr>
            <p:cNvPr id="113" name="Left Bracket 112"/>
            <p:cNvSpPr/>
            <p:nvPr/>
          </p:nvSpPr>
          <p:spPr>
            <a:xfrm>
              <a:off x="669747" y="1653445"/>
              <a:ext cx="62554" cy="1517434"/>
            </a:xfrm>
            <a:prstGeom prst="leftBracket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687360" y="1519206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p</a:t>
              </a: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687360" y="3005899"/>
              <a:ext cx="2375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c</a:t>
              </a:r>
            </a:p>
          </p:txBody>
        </p:sp>
      </p:grpSp>
      <p:grpSp>
        <p:nvGrpSpPr>
          <p:cNvPr id="116" name="Group 115"/>
          <p:cNvGrpSpPr/>
          <p:nvPr/>
        </p:nvGrpSpPr>
        <p:grpSpPr>
          <a:xfrm>
            <a:off x="884397" y="4563393"/>
            <a:ext cx="490663" cy="2416452"/>
            <a:chOff x="6001504" y="1177121"/>
            <a:chExt cx="490663" cy="2416452"/>
          </a:xfrm>
        </p:grpSpPr>
        <p:sp>
          <p:nvSpPr>
            <p:cNvPr id="117" name="TextBox 116"/>
            <p:cNvSpPr txBox="1"/>
            <p:nvPr/>
          </p:nvSpPr>
          <p:spPr>
            <a:xfrm>
              <a:off x="6008760" y="117712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70</a:t>
              </a: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6010545" y="1550682"/>
              <a:ext cx="4676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30</a:t>
              </a: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6001504" y="2144750"/>
              <a:ext cx="4676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00</a:t>
              </a:r>
              <a:endParaRPr lang="en-US" sz="1000" b="1" dirty="0">
                <a:solidFill>
                  <a:srgbClr val="FFFF00"/>
                </a:solidFill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6024495" y="2776867"/>
              <a:ext cx="4676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70</a:t>
              </a:r>
              <a:endParaRPr lang="en-US" sz="900" b="1" dirty="0">
                <a:solidFill>
                  <a:srgbClr val="FFFF00"/>
                </a:solidFill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6009418" y="3378129"/>
              <a:ext cx="4676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55</a:t>
              </a:r>
              <a:endParaRPr lang="en-US" sz="1000" b="1" dirty="0">
                <a:solidFill>
                  <a:srgbClr val="FFFF00"/>
                </a:solidFill>
              </a:endParaRPr>
            </a:p>
          </p:txBody>
        </p:sp>
      </p:grpSp>
      <p:sp>
        <p:nvSpPr>
          <p:cNvPr id="41" name="TextBox 40"/>
          <p:cNvSpPr txBox="1"/>
          <p:nvPr/>
        </p:nvSpPr>
        <p:spPr>
          <a:xfrm>
            <a:off x="1529103" y="3516885"/>
            <a:ext cx="11118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u="sng" dirty="0"/>
              <a:t>Long exposure</a:t>
            </a:r>
            <a:endParaRPr lang="en-US" sz="1200" b="1" u="sng" dirty="0"/>
          </a:p>
        </p:txBody>
      </p:sp>
      <p:sp>
        <p:nvSpPr>
          <p:cNvPr id="122" name="TextBox 121"/>
          <p:cNvSpPr txBox="1"/>
          <p:nvPr/>
        </p:nvSpPr>
        <p:spPr>
          <a:xfrm>
            <a:off x="1529103" y="7049048"/>
            <a:ext cx="1151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u="sng" dirty="0"/>
              <a:t>Short exposure</a:t>
            </a:r>
            <a:endParaRPr lang="en-US" sz="1200" b="1" u="sng" dirty="0"/>
          </a:p>
        </p:txBody>
      </p:sp>
    </p:spTree>
    <p:extLst>
      <p:ext uri="{BB962C8B-B14F-4D97-AF65-F5344CB8AC3E}">
        <p14:creationId xmlns:p14="http://schemas.microsoft.com/office/powerpoint/2010/main" val="12382834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9426"/>
          <a:stretch/>
        </p:blipFill>
        <p:spPr>
          <a:xfrm>
            <a:off x="3680022" y="1738768"/>
            <a:ext cx="2708670" cy="223246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b="13438"/>
          <a:stretch/>
        </p:blipFill>
        <p:spPr>
          <a:xfrm>
            <a:off x="852548" y="1707599"/>
            <a:ext cx="2715775" cy="226363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/>
          <a:srcRect b="9735"/>
          <a:stretch/>
        </p:blipFill>
        <p:spPr>
          <a:xfrm>
            <a:off x="3568323" y="5190265"/>
            <a:ext cx="2685227" cy="2010338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>
            <a:off x="763000" y="1654844"/>
            <a:ext cx="437499" cy="1987056"/>
            <a:chOff x="272207" y="6487883"/>
            <a:chExt cx="493943" cy="2126154"/>
          </a:xfrm>
        </p:grpSpPr>
        <p:sp>
          <p:nvSpPr>
            <p:cNvPr id="6" name="TextBox 5"/>
            <p:cNvSpPr txBox="1"/>
            <p:nvPr/>
          </p:nvSpPr>
          <p:spPr>
            <a:xfrm>
              <a:off x="282605" y="6487883"/>
              <a:ext cx="382233" cy="2305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70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81469" y="6789957"/>
              <a:ext cx="467671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30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72207" y="7355982"/>
              <a:ext cx="467671" cy="2305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00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94044" y="7873804"/>
              <a:ext cx="467671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70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98479" y="8383511"/>
              <a:ext cx="467671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55</a:t>
              </a: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3596386" y="1727405"/>
            <a:ext cx="452443" cy="1863264"/>
            <a:chOff x="267112" y="6518758"/>
            <a:chExt cx="510816" cy="1993696"/>
          </a:xfrm>
        </p:grpSpPr>
        <p:sp>
          <p:nvSpPr>
            <p:cNvPr id="12" name="TextBox 11"/>
            <p:cNvSpPr txBox="1"/>
            <p:nvPr/>
          </p:nvSpPr>
          <p:spPr>
            <a:xfrm>
              <a:off x="281792" y="6518758"/>
              <a:ext cx="382233" cy="2305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70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67112" y="6857353"/>
              <a:ext cx="467671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30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67112" y="7379171"/>
              <a:ext cx="467671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00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94704" y="7875372"/>
              <a:ext cx="467671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70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10257" y="8281928"/>
              <a:ext cx="467671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55</a:t>
              </a:r>
            </a:p>
          </p:txBody>
        </p:sp>
      </p:grpSp>
      <p:grpSp>
        <p:nvGrpSpPr>
          <p:cNvPr id="17" name="Group 16"/>
          <p:cNvGrpSpPr/>
          <p:nvPr/>
        </p:nvGrpSpPr>
        <p:grpSpPr>
          <a:xfrm>
            <a:off x="984845" y="754889"/>
            <a:ext cx="2583478" cy="949274"/>
            <a:chOff x="522674" y="5524926"/>
            <a:chExt cx="2916789" cy="1015725"/>
          </a:xfrm>
        </p:grpSpPr>
        <p:grpSp>
          <p:nvGrpSpPr>
            <p:cNvPr id="18" name="Group 17"/>
            <p:cNvGrpSpPr/>
            <p:nvPr/>
          </p:nvGrpSpPr>
          <p:grpSpPr>
            <a:xfrm>
              <a:off x="634025" y="5798862"/>
              <a:ext cx="2805438" cy="741789"/>
              <a:chOff x="4271516" y="2044427"/>
              <a:chExt cx="2805438" cy="741789"/>
            </a:xfrm>
          </p:grpSpPr>
          <p:sp>
            <p:nvSpPr>
              <p:cNvPr id="21" name="TextBox 20"/>
              <p:cNvSpPr txBox="1"/>
              <p:nvPr/>
            </p:nvSpPr>
            <p:spPr>
              <a:xfrm>
                <a:off x="4271516" y="2091856"/>
                <a:ext cx="583123" cy="2634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MBCD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4973909" y="2044427"/>
                <a:ext cx="431099" cy="2634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CO</a:t>
                </a:r>
                <a:r>
                  <a:rPr lang="en-US" sz="1000" b="1" baseline="-25000" dirty="0"/>
                  <a:t>2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4271516" y="2497946"/>
                <a:ext cx="592500" cy="2634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-      +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871146" y="2522759"/>
                <a:ext cx="729718" cy="2634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5%     1%</a:t>
                </a:r>
              </a:p>
            </p:txBody>
          </p:sp>
          <p:cxnSp>
            <p:nvCxnSpPr>
              <p:cNvPr id="25" name="Straight Connector 24"/>
              <p:cNvCxnSpPr/>
              <p:nvPr/>
            </p:nvCxnSpPr>
            <p:spPr>
              <a:xfrm>
                <a:off x="6435656" y="2337388"/>
                <a:ext cx="4049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6" name="TextBox 25"/>
              <p:cNvSpPr txBox="1"/>
              <p:nvPr/>
            </p:nvSpPr>
            <p:spPr>
              <a:xfrm>
                <a:off x="5586449" y="2460377"/>
                <a:ext cx="679146" cy="2634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-       +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6289099" y="2485542"/>
                <a:ext cx="787855" cy="2634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5%     1%</a:t>
                </a:r>
              </a:p>
            </p:txBody>
          </p:sp>
          <p:cxnSp>
            <p:nvCxnSpPr>
              <p:cNvPr id="28" name="Straight Connector 27"/>
              <p:cNvCxnSpPr/>
              <p:nvPr/>
            </p:nvCxnSpPr>
            <p:spPr>
              <a:xfrm>
                <a:off x="5723572" y="2337388"/>
                <a:ext cx="4049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4991860" y="2344097"/>
                <a:ext cx="4049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>
                <a:off x="4327938" y="2337388"/>
                <a:ext cx="4049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1" name="TextBox 30"/>
              <p:cNvSpPr txBox="1"/>
              <p:nvPr/>
            </p:nvSpPr>
            <p:spPr>
              <a:xfrm>
                <a:off x="6435656" y="2072446"/>
                <a:ext cx="431099" cy="2634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CO</a:t>
                </a:r>
                <a:r>
                  <a:rPr lang="en-US" sz="1000" b="1" baseline="-25000" dirty="0"/>
                  <a:t>2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5675588" y="2082487"/>
                <a:ext cx="583123" cy="2634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MBCD</a:t>
                </a:r>
              </a:p>
            </p:txBody>
          </p:sp>
        </p:grpSp>
        <p:sp>
          <p:nvSpPr>
            <p:cNvPr id="19" name="TextBox 18"/>
            <p:cNvSpPr txBox="1"/>
            <p:nvPr/>
          </p:nvSpPr>
          <p:spPr>
            <a:xfrm>
              <a:off x="522674" y="5524926"/>
              <a:ext cx="1439166" cy="2634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Cytoplasmic fraction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50392" y="5524926"/>
              <a:ext cx="1173123" cy="2634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Nuclear fraction</a:t>
              </a:r>
            </a:p>
          </p:txBody>
        </p:sp>
      </p:grpSp>
      <p:grpSp>
        <p:nvGrpSpPr>
          <p:cNvPr id="33" name="Group 32"/>
          <p:cNvGrpSpPr/>
          <p:nvPr/>
        </p:nvGrpSpPr>
        <p:grpSpPr>
          <a:xfrm>
            <a:off x="3789044" y="754383"/>
            <a:ext cx="2583478" cy="949274"/>
            <a:chOff x="522674" y="5524926"/>
            <a:chExt cx="2916789" cy="1015725"/>
          </a:xfrm>
        </p:grpSpPr>
        <p:grpSp>
          <p:nvGrpSpPr>
            <p:cNvPr id="34" name="Group 33"/>
            <p:cNvGrpSpPr/>
            <p:nvPr/>
          </p:nvGrpSpPr>
          <p:grpSpPr>
            <a:xfrm>
              <a:off x="634025" y="5798862"/>
              <a:ext cx="2805438" cy="741789"/>
              <a:chOff x="4271516" y="2044427"/>
              <a:chExt cx="2805438" cy="741789"/>
            </a:xfrm>
          </p:grpSpPr>
          <p:sp>
            <p:nvSpPr>
              <p:cNvPr id="37" name="TextBox 36"/>
              <p:cNvSpPr txBox="1"/>
              <p:nvPr/>
            </p:nvSpPr>
            <p:spPr>
              <a:xfrm>
                <a:off x="4271516" y="2091856"/>
                <a:ext cx="583123" cy="2634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MBCD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4973909" y="2044427"/>
                <a:ext cx="431099" cy="2634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CO</a:t>
                </a:r>
                <a:r>
                  <a:rPr lang="en-US" sz="1000" b="1" baseline="-25000" dirty="0"/>
                  <a:t>2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4271516" y="2497946"/>
                <a:ext cx="592500" cy="2634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-      +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4871146" y="2522759"/>
                <a:ext cx="729718" cy="2634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5%     1%</a:t>
                </a:r>
              </a:p>
            </p:txBody>
          </p:sp>
          <p:cxnSp>
            <p:nvCxnSpPr>
              <p:cNvPr id="41" name="Straight Connector 40"/>
              <p:cNvCxnSpPr/>
              <p:nvPr/>
            </p:nvCxnSpPr>
            <p:spPr>
              <a:xfrm>
                <a:off x="6435656" y="2337388"/>
                <a:ext cx="4049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2" name="TextBox 41"/>
              <p:cNvSpPr txBox="1"/>
              <p:nvPr/>
            </p:nvSpPr>
            <p:spPr>
              <a:xfrm>
                <a:off x="5586449" y="2460377"/>
                <a:ext cx="679146" cy="2634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-       +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6289099" y="2485542"/>
                <a:ext cx="787855" cy="2634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5%     1%</a:t>
                </a:r>
              </a:p>
            </p:txBody>
          </p:sp>
          <p:cxnSp>
            <p:nvCxnSpPr>
              <p:cNvPr id="44" name="Straight Connector 43"/>
              <p:cNvCxnSpPr/>
              <p:nvPr/>
            </p:nvCxnSpPr>
            <p:spPr>
              <a:xfrm>
                <a:off x="5723572" y="2337388"/>
                <a:ext cx="4049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>
                <a:off x="4991860" y="2344097"/>
                <a:ext cx="4049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/>
              <p:cNvCxnSpPr/>
              <p:nvPr/>
            </p:nvCxnSpPr>
            <p:spPr>
              <a:xfrm>
                <a:off x="4327938" y="2337388"/>
                <a:ext cx="4049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7" name="TextBox 46"/>
              <p:cNvSpPr txBox="1"/>
              <p:nvPr/>
            </p:nvSpPr>
            <p:spPr>
              <a:xfrm>
                <a:off x="6435656" y="2072446"/>
                <a:ext cx="431099" cy="2634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CO</a:t>
                </a:r>
                <a:r>
                  <a:rPr lang="en-US" sz="1000" b="1" baseline="-25000" dirty="0"/>
                  <a:t>2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5675588" y="2082487"/>
                <a:ext cx="583123" cy="2634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MBCD</a:t>
                </a:r>
              </a:p>
            </p:txBody>
          </p:sp>
        </p:grpSp>
        <p:sp>
          <p:nvSpPr>
            <p:cNvPr id="35" name="TextBox 34"/>
            <p:cNvSpPr txBox="1"/>
            <p:nvPr/>
          </p:nvSpPr>
          <p:spPr>
            <a:xfrm>
              <a:off x="522674" y="5524926"/>
              <a:ext cx="1439166" cy="2634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Cytoplasmic fraction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050392" y="5524926"/>
              <a:ext cx="1173123" cy="2634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Nuclear fraction</a:t>
              </a:r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6341481" y="3129003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U2AF65</a:t>
            </a:r>
          </a:p>
        </p:txBody>
      </p:sp>
      <p:grpSp>
        <p:nvGrpSpPr>
          <p:cNvPr id="50" name="Group 49"/>
          <p:cNvGrpSpPr/>
          <p:nvPr/>
        </p:nvGrpSpPr>
        <p:grpSpPr>
          <a:xfrm>
            <a:off x="140782" y="1928561"/>
            <a:ext cx="781840" cy="1414676"/>
            <a:chOff x="1030151" y="1956238"/>
            <a:chExt cx="882710" cy="1513706"/>
          </a:xfrm>
        </p:grpSpPr>
        <p:sp>
          <p:nvSpPr>
            <p:cNvPr id="51" name="TextBox 50"/>
            <p:cNvSpPr txBox="1"/>
            <p:nvPr/>
          </p:nvSpPr>
          <p:spPr>
            <a:xfrm>
              <a:off x="1030151" y="2721117"/>
              <a:ext cx="695332" cy="2634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SREBP2 </a:t>
              </a:r>
            </a:p>
          </p:txBody>
        </p:sp>
        <p:sp>
          <p:nvSpPr>
            <p:cNvPr id="52" name="Left Bracket 51"/>
            <p:cNvSpPr/>
            <p:nvPr/>
          </p:nvSpPr>
          <p:spPr>
            <a:xfrm>
              <a:off x="1640129" y="2095399"/>
              <a:ext cx="59492" cy="1278713"/>
            </a:xfrm>
            <a:prstGeom prst="leftBracket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626547" y="1956238"/>
              <a:ext cx="286314" cy="2634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p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639921" y="3206487"/>
              <a:ext cx="268216" cy="2634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c</a:t>
              </a:r>
            </a:p>
          </p:txBody>
        </p:sp>
      </p:grpSp>
      <p:sp>
        <p:nvSpPr>
          <p:cNvPr id="55" name="TextBox 54"/>
          <p:cNvSpPr txBox="1"/>
          <p:nvPr/>
        </p:nvSpPr>
        <p:spPr>
          <a:xfrm>
            <a:off x="6341481" y="339841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Tubulin</a:t>
            </a:r>
          </a:p>
        </p:txBody>
      </p:sp>
      <p:sp>
        <p:nvSpPr>
          <p:cNvPr id="57" name="Rectangle 56"/>
          <p:cNvSpPr/>
          <p:nvPr/>
        </p:nvSpPr>
        <p:spPr>
          <a:xfrm>
            <a:off x="2837195" y="3081451"/>
            <a:ext cx="700481" cy="435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59" name="Rectangle 58"/>
          <p:cNvSpPr/>
          <p:nvPr/>
        </p:nvSpPr>
        <p:spPr>
          <a:xfrm>
            <a:off x="4446277" y="3307329"/>
            <a:ext cx="610337" cy="2506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60" name="TextBox 59"/>
          <p:cNvSpPr txBox="1"/>
          <p:nvPr/>
        </p:nvSpPr>
        <p:spPr>
          <a:xfrm>
            <a:off x="170700" y="484618"/>
            <a:ext cx="8896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/>
              <a:t>Figure 3D</a:t>
            </a:r>
          </a:p>
        </p:txBody>
      </p:sp>
      <p:pic>
        <p:nvPicPr>
          <p:cNvPr id="64" name="Picture 6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3329" y="5190264"/>
            <a:ext cx="2711717" cy="2010339"/>
          </a:xfrm>
          <a:prstGeom prst="rect">
            <a:avLst/>
          </a:prstGeom>
        </p:spPr>
      </p:pic>
      <p:sp>
        <p:nvSpPr>
          <p:cNvPr id="65" name="TextBox 64"/>
          <p:cNvSpPr txBox="1"/>
          <p:nvPr/>
        </p:nvSpPr>
        <p:spPr>
          <a:xfrm>
            <a:off x="1586353" y="4023990"/>
            <a:ext cx="11118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u="sng" dirty="0"/>
              <a:t>Long exposure</a:t>
            </a:r>
            <a:endParaRPr lang="en-US" sz="1200" b="1" u="sng" dirty="0"/>
          </a:p>
        </p:txBody>
      </p:sp>
      <p:sp>
        <p:nvSpPr>
          <p:cNvPr id="66" name="TextBox 65"/>
          <p:cNvSpPr txBox="1"/>
          <p:nvPr/>
        </p:nvSpPr>
        <p:spPr>
          <a:xfrm>
            <a:off x="1492077" y="7282029"/>
            <a:ext cx="1151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u="sng" dirty="0"/>
              <a:t>Short exposure</a:t>
            </a:r>
            <a:endParaRPr lang="en-US" sz="1200" b="1" u="sng" dirty="0"/>
          </a:p>
        </p:txBody>
      </p:sp>
      <p:grpSp>
        <p:nvGrpSpPr>
          <p:cNvPr id="67" name="Group 66"/>
          <p:cNvGrpSpPr/>
          <p:nvPr/>
        </p:nvGrpSpPr>
        <p:grpSpPr>
          <a:xfrm>
            <a:off x="-3591" y="5509961"/>
            <a:ext cx="781840" cy="1017839"/>
            <a:chOff x="1030151" y="1956238"/>
            <a:chExt cx="882710" cy="1513706"/>
          </a:xfrm>
        </p:grpSpPr>
        <p:sp>
          <p:nvSpPr>
            <p:cNvPr id="68" name="TextBox 67"/>
            <p:cNvSpPr txBox="1"/>
            <p:nvPr/>
          </p:nvSpPr>
          <p:spPr>
            <a:xfrm>
              <a:off x="1030151" y="2721117"/>
              <a:ext cx="695332" cy="2634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SREBP2 </a:t>
              </a:r>
            </a:p>
          </p:txBody>
        </p:sp>
        <p:sp>
          <p:nvSpPr>
            <p:cNvPr id="69" name="Left Bracket 68"/>
            <p:cNvSpPr/>
            <p:nvPr/>
          </p:nvSpPr>
          <p:spPr>
            <a:xfrm>
              <a:off x="1640129" y="2095399"/>
              <a:ext cx="59492" cy="1278713"/>
            </a:xfrm>
            <a:prstGeom prst="leftBracket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1626547" y="1956238"/>
              <a:ext cx="286314" cy="2634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p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1639921" y="3206487"/>
              <a:ext cx="268216" cy="2634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c</a:t>
              </a:r>
            </a:p>
          </p:txBody>
        </p:sp>
      </p:grpSp>
      <p:grpSp>
        <p:nvGrpSpPr>
          <p:cNvPr id="72" name="Group 71"/>
          <p:cNvGrpSpPr/>
          <p:nvPr/>
        </p:nvGrpSpPr>
        <p:grpSpPr>
          <a:xfrm>
            <a:off x="686158" y="5237686"/>
            <a:ext cx="459573" cy="1683147"/>
            <a:chOff x="272930" y="6487883"/>
            <a:chExt cx="518864" cy="1800971"/>
          </a:xfrm>
        </p:grpSpPr>
        <p:sp>
          <p:nvSpPr>
            <p:cNvPr id="73" name="TextBox 72"/>
            <p:cNvSpPr txBox="1"/>
            <p:nvPr/>
          </p:nvSpPr>
          <p:spPr>
            <a:xfrm>
              <a:off x="282605" y="6487883"/>
              <a:ext cx="382233" cy="2305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70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281469" y="6789957"/>
              <a:ext cx="467671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30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272930" y="7258037"/>
              <a:ext cx="467671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00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91437" y="7705511"/>
              <a:ext cx="467672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70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324122" y="8058328"/>
              <a:ext cx="467672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55</a:t>
              </a:r>
            </a:p>
          </p:txBody>
        </p:sp>
      </p:grpSp>
      <p:grpSp>
        <p:nvGrpSpPr>
          <p:cNvPr id="78" name="Group 77"/>
          <p:cNvGrpSpPr/>
          <p:nvPr/>
        </p:nvGrpSpPr>
        <p:grpSpPr>
          <a:xfrm>
            <a:off x="3467570" y="5191873"/>
            <a:ext cx="433890" cy="1649917"/>
            <a:chOff x="272930" y="6487883"/>
            <a:chExt cx="489868" cy="1765415"/>
          </a:xfrm>
        </p:grpSpPr>
        <p:sp>
          <p:nvSpPr>
            <p:cNvPr id="79" name="TextBox 78"/>
            <p:cNvSpPr txBox="1"/>
            <p:nvPr/>
          </p:nvSpPr>
          <p:spPr>
            <a:xfrm>
              <a:off x="282605" y="6487883"/>
              <a:ext cx="382233" cy="2305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70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81469" y="6789957"/>
              <a:ext cx="467671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30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72930" y="7195816"/>
              <a:ext cx="467671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00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95126" y="7639267"/>
              <a:ext cx="467672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70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295126" y="8022772"/>
              <a:ext cx="467672" cy="2305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55</a:t>
              </a:r>
            </a:p>
          </p:txBody>
        </p:sp>
      </p:grpSp>
      <p:sp>
        <p:nvSpPr>
          <p:cNvPr id="84" name="TextBox 83"/>
          <p:cNvSpPr txBox="1"/>
          <p:nvPr/>
        </p:nvSpPr>
        <p:spPr>
          <a:xfrm>
            <a:off x="6253550" y="6405200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U2AF65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6253550" y="6674612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Tubulin</a:t>
            </a:r>
          </a:p>
        </p:txBody>
      </p:sp>
      <p:sp>
        <p:nvSpPr>
          <p:cNvPr id="88" name="Rectangle 87"/>
          <p:cNvSpPr/>
          <p:nvPr/>
        </p:nvSpPr>
        <p:spPr>
          <a:xfrm>
            <a:off x="1565527" y="5410190"/>
            <a:ext cx="541159" cy="435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89" name="Rectangle 88"/>
          <p:cNvSpPr/>
          <p:nvPr/>
        </p:nvSpPr>
        <p:spPr>
          <a:xfrm>
            <a:off x="5505278" y="6350647"/>
            <a:ext cx="700481" cy="435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</p:spTree>
    <p:extLst>
      <p:ext uri="{BB962C8B-B14F-4D97-AF65-F5344CB8AC3E}">
        <p14:creationId xmlns:p14="http://schemas.microsoft.com/office/powerpoint/2010/main" val="36694819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7119" y="1792938"/>
            <a:ext cx="1743622" cy="247147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3586" y="1792938"/>
            <a:ext cx="1742664" cy="247147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433473" y="3457191"/>
            <a:ext cx="1788655" cy="4009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7" name="TextBox 6"/>
          <p:cNvSpPr txBox="1"/>
          <p:nvPr/>
        </p:nvSpPr>
        <p:spPr>
          <a:xfrm rot="16200000">
            <a:off x="1469546" y="1432840"/>
            <a:ext cx="4780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iNT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325538" y="940146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1% CO</a:t>
            </a:r>
            <a:r>
              <a:rPr lang="en-US" sz="1000" b="1" baseline="-25000" dirty="0"/>
              <a:t>2</a:t>
            </a:r>
          </a:p>
        </p:txBody>
      </p:sp>
      <p:sp>
        <p:nvSpPr>
          <p:cNvPr id="9" name="Rectangle 8"/>
          <p:cNvSpPr/>
          <p:nvPr/>
        </p:nvSpPr>
        <p:spPr>
          <a:xfrm rot="16200000">
            <a:off x="1698345" y="1361375"/>
            <a:ext cx="65594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siSREBP2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2182310" y="1455451"/>
            <a:ext cx="4780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iNTC</a:t>
            </a:r>
          </a:p>
        </p:txBody>
      </p:sp>
      <p:sp>
        <p:nvSpPr>
          <p:cNvPr id="11" name="Rectangle 10"/>
          <p:cNvSpPr/>
          <p:nvPr/>
        </p:nvSpPr>
        <p:spPr>
          <a:xfrm rot="16200000">
            <a:off x="2411111" y="1383986"/>
            <a:ext cx="65594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siSREBP2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604173" y="940146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5% CO</a:t>
            </a:r>
            <a:r>
              <a:rPr lang="en-US" sz="1000" b="1" baseline="-25000" dirty="0"/>
              <a:t>2</a:t>
            </a:r>
          </a:p>
        </p:txBody>
      </p:sp>
      <p:sp>
        <p:nvSpPr>
          <p:cNvPr id="14" name="Rectangle 13"/>
          <p:cNvSpPr/>
          <p:nvPr/>
        </p:nvSpPr>
        <p:spPr>
          <a:xfrm>
            <a:off x="1217118" y="3509124"/>
            <a:ext cx="1740993" cy="2980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grpSp>
        <p:nvGrpSpPr>
          <p:cNvPr id="15" name="Group 14"/>
          <p:cNvGrpSpPr/>
          <p:nvPr/>
        </p:nvGrpSpPr>
        <p:grpSpPr>
          <a:xfrm>
            <a:off x="493340" y="2066094"/>
            <a:ext cx="800810" cy="1675993"/>
            <a:chOff x="-35436" y="1519206"/>
            <a:chExt cx="1013206" cy="2079736"/>
          </a:xfrm>
        </p:grpSpPr>
        <p:sp>
          <p:nvSpPr>
            <p:cNvPr id="39" name="TextBox 38"/>
            <p:cNvSpPr txBox="1"/>
            <p:nvPr/>
          </p:nvSpPr>
          <p:spPr>
            <a:xfrm>
              <a:off x="-35436" y="2358861"/>
              <a:ext cx="742713" cy="3055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SREBP2</a:t>
              </a:r>
            </a:p>
          </p:txBody>
        </p:sp>
        <p:sp>
          <p:nvSpPr>
            <p:cNvPr id="40" name="Left Bracket 39"/>
            <p:cNvSpPr/>
            <p:nvPr/>
          </p:nvSpPr>
          <p:spPr>
            <a:xfrm>
              <a:off x="639300" y="1653444"/>
              <a:ext cx="67969" cy="1818298"/>
            </a:xfrm>
            <a:prstGeom prst="leftBracket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656912" y="1519206"/>
              <a:ext cx="320858" cy="3055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p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41689" y="3293407"/>
              <a:ext cx="300575" cy="3055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c</a:t>
              </a:r>
            </a:p>
          </p:txBody>
        </p:sp>
      </p:grpSp>
      <p:cxnSp>
        <p:nvCxnSpPr>
          <p:cNvPr id="16" name="Straight Connector 15"/>
          <p:cNvCxnSpPr/>
          <p:nvPr/>
        </p:nvCxnSpPr>
        <p:spPr>
          <a:xfrm flipV="1">
            <a:off x="1647157" y="1187826"/>
            <a:ext cx="490364" cy="4191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V="1">
            <a:off x="2370351" y="1194895"/>
            <a:ext cx="490364" cy="4191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5225320" y="3639580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U2AF65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3645639" y="1425860"/>
            <a:ext cx="4780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iNTC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501632" y="933166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1% CO</a:t>
            </a:r>
            <a:r>
              <a:rPr lang="en-US" sz="1000" b="1" baseline="-25000" dirty="0"/>
              <a:t>2</a:t>
            </a:r>
          </a:p>
        </p:txBody>
      </p:sp>
      <p:sp>
        <p:nvSpPr>
          <p:cNvPr id="21" name="Rectangle 20"/>
          <p:cNvSpPr/>
          <p:nvPr/>
        </p:nvSpPr>
        <p:spPr>
          <a:xfrm rot="16200000">
            <a:off x="3874439" y="1372368"/>
            <a:ext cx="65594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siSREBP2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4358403" y="1448471"/>
            <a:ext cx="4780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iNTC</a:t>
            </a:r>
          </a:p>
        </p:txBody>
      </p:sp>
      <p:sp>
        <p:nvSpPr>
          <p:cNvPr id="23" name="Rectangle 22"/>
          <p:cNvSpPr/>
          <p:nvPr/>
        </p:nvSpPr>
        <p:spPr>
          <a:xfrm rot="16200000">
            <a:off x="4587203" y="1350047"/>
            <a:ext cx="65594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siSREBP2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0265" y="933166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5% CO</a:t>
            </a:r>
            <a:r>
              <a:rPr lang="en-US" sz="1000" b="1" baseline="-25000" dirty="0"/>
              <a:t>2</a:t>
            </a:r>
          </a:p>
        </p:txBody>
      </p:sp>
      <p:cxnSp>
        <p:nvCxnSpPr>
          <p:cNvPr id="25" name="Straight Connector 24"/>
          <p:cNvCxnSpPr/>
          <p:nvPr/>
        </p:nvCxnSpPr>
        <p:spPr>
          <a:xfrm flipV="1">
            <a:off x="3823250" y="1180846"/>
            <a:ext cx="490364" cy="4191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V="1">
            <a:off x="4546444" y="1187915"/>
            <a:ext cx="490364" cy="4191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grpSp>
        <p:nvGrpSpPr>
          <p:cNvPr id="27" name="Group 26"/>
          <p:cNvGrpSpPr/>
          <p:nvPr/>
        </p:nvGrpSpPr>
        <p:grpSpPr>
          <a:xfrm>
            <a:off x="1155154" y="1735139"/>
            <a:ext cx="418513" cy="2337754"/>
            <a:chOff x="5924147" y="1142178"/>
            <a:chExt cx="529514" cy="2900913"/>
          </a:xfrm>
        </p:grpSpPr>
        <p:sp>
          <p:nvSpPr>
            <p:cNvPr id="34" name="TextBox 33"/>
            <p:cNvSpPr txBox="1"/>
            <p:nvPr/>
          </p:nvSpPr>
          <p:spPr>
            <a:xfrm>
              <a:off x="5932942" y="1142178"/>
              <a:ext cx="428348" cy="2673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70</a:t>
              </a:r>
              <a:endParaRPr lang="en-US" sz="1000" b="1" dirty="0">
                <a:solidFill>
                  <a:srgbClr val="FFFF00"/>
                </a:solidFill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953991" y="1562527"/>
              <a:ext cx="496547" cy="26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30</a:t>
              </a:r>
              <a:endParaRPr lang="en-US" sz="1000" b="1" dirty="0">
                <a:solidFill>
                  <a:srgbClr val="FFFF00"/>
                </a:solidFill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924147" y="2349757"/>
              <a:ext cx="518124" cy="26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00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985989" y="3089361"/>
              <a:ext cx="467672" cy="26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70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982866" y="3775747"/>
              <a:ext cx="467672" cy="26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55</a:t>
              </a:r>
            </a:p>
          </p:txBody>
        </p:sp>
      </p:grpSp>
      <p:grpSp>
        <p:nvGrpSpPr>
          <p:cNvPr id="28" name="Group 27"/>
          <p:cNvGrpSpPr/>
          <p:nvPr/>
        </p:nvGrpSpPr>
        <p:grpSpPr>
          <a:xfrm>
            <a:off x="3410630" y="1751266"/>
            <a:ext cx="428039" cy="2387346"/>
            <a:chOff x="5932617" y="1168374"/>
            <a:chExt cx="541566" cy="2962452"/>
          </a:xfrm>
        </p:grpSpPr>
        <p:sp>
          <p:nvSpPr>
            <p:cNvPr id="29" name="TextBox 28"/>
            <p:cNvSpPr txBox="1"/>
            <p:nvPr/>
          </p:nvSpPr>
          <p:spPr>
            <a:xfrm>
              <a:off x="5991074" y="1168374"/>
              <a:ext cx="428348" cy="2673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70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991744" y="1558657"/>
              <a:ext cx="482439" cy="26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30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970166" y="2378017"/>
              <a:ext cx="504017" cy="26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00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5951749" y="3125726"/>
              <a:ext cx="467672" cy="26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70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932617" y="3863482"/>
              <a:ext cx="467672" cy="26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55</a:t>
              </a:r>
            </a:p>
          </p:txBody>
        </p:sp>
      </p:grpSp>
      <p:sp>
        <p:nvSpPr>
          <p:cNvPr id="48" name="TextBox 47"/>
          <p:cNvSpPr txBox="1"/>
          <p:nvPr/>
        </p:nvSpPr>
        <p:spPr>
          <a:xfrm>
            <a:off x="286696" y="832227"/>
            <a:ext cx="9296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/>
              <a:t>Figure 3G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78742" y="5204608"/>
            <a:ext cx="1863279" cy="2564315"/>
          </a:xfrm>
          <a:prstGeom prst="rect">
            <a:avLst/>
          </a:prstGeom>
        </p:spPr>
      </p:pic>
      <p:grpSp>
        <p:nvGrpSpPr>
          <p:cNvPr id="109" name="Group 108"/>
          <p:cNvGrpSpPr/>
          <p:nvPr/>
        </p:nvGrpSpPr>
        <p:grpSpPr>
          <a:xfrm>
            <a:off x="377932" y="5533194"/>
            <a:ext cx="800810" cy="1675993"/>
            <a:chOff x="-35436" y="1519206"/>
            <a:chExt cx="1013206" cy="2079736"/>
          </a:xfrm>
        </p:grpSpPr>
        <p:sp>
          <p:nvSpPr>
            <p:cNvPr id="111" name="TextBox 110"/>
            <p:cNvSpPr txBox="1"/>
            <p:nvPr/>
          </p:nvSpPr>
          <p:spPr>
            <a:xfrm>
              <a:off x="-35436" y="2358861"/>
              <a:ext cx="742713" cy="3055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SREBP2</a:t>
              </a:r>
            </a:p>
          </p:txBody>
        </p:sp>
        <p:sp>
          <p:nvSpPr>
            <p:cNvPr id="113" name="Left Bracket 112"/>
            <p:cNvSpPr/>
            <p:nvPr/>
          </p:nvSpPr>
          <p:spPr>
            <a:xfrm>
              <a:off x="639300" y="1653444"/>
              <a:ext cx="67969" cy="1818298"/>
            </a:xfrm>
            <a:prstGeom prst="leftBracket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656912" y="1519206"/>
              <a:ext cx="320858" cy="3055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p</a:t>
              </a: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641689" y="3293407"/>
              <a:ext cx="300575" cy="3055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c</a:t>
              </a:r>
            </a:p>
          </p:txBody>
        </p:sp>
      </p:grpSp>
      <p:sp>
        <p:nvSpPr>
          <p:cNvPr id="116" name="Rectangle 115"/>
          <p:cNvSpPr/>
          <p:nvPr/>
        </p:nvSpPr>
        <p:spPr>
          <a:xfrm>
            <a:off x="1217118" y="5507293"/>
            <a:ext cx="1824903" cy="2721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grpSp>
        <p:nvGrpSpPr>
          <p:cNvPr id="117" name="Group 116"/>
          <p:cNvGrpSpPr/>
          <p:nvPr/>
        </p:nvGrpSpPr>
        <p:grpSpPr>
          <a:xfrm>
            <a:off x="1143265" y="5197872"/>
            <a:ext cx="418513" cy="2345960"/>
            <a:chOff x="5924147" y="1131995"/>
            <a:chExt cx="529514" cy="2911096"/>
          </a:xfrm>
        </p:grpSpPr>
        <p:sp>
          <p:nvSpPr>
            <p:cNvPr id="118" name="TextBox 117"/>
            <p:cNvSpPr txBox="1"/>
            <p:nvPr/>
          </p:nvSpPr>
          <p:spPr>
            <a:xfrm>
              <a:off x="5984077" y="1131995"/>
              <a:ext cx="428348" cy="2673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70</a:t>
              </a:r>
              <a:endParaRPr lang="en-US" sz="1000" b="1" dirty="0">
                <a:solidFill>
                  <a:srgbClr val="FFFF00"/>
                </a:solidFill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5953991" y="1562527"/>
              <a:ext cx="496547" cy="26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30</a:t>
              </a:r>
              <a:endParaRPr lang="en-US" sz="1000" b="1" dirty="0">
                <a:solidFill>
                  <a:srgbClr val="FFFF00"/>
                </a:solidFill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5924147" y="2349757"/>
              <a:ext cx="518124" cy="26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100</a:t>
              </a: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5985989" y="3089361"/>
              <a:ext cx="467672" cy="26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70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5982866" y="3775747"/>
              <a:ext cx="467672" cy="26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FF00"/>
                  </a:solidFill>
                </a:rPr>
                <a:t>55</a:t>
              </a:r>
            </a:p>
          </p:txBody>
        </p:sp>
      </p:grpSp>
      <p:sp>
        <p:nvSpPr>
          <p:cNvPr id="123" name="TextBox 122"/>
          <p:cNvSpPr txBox="1"/>
          <p:nvPr/>
        </p:nvSpPr>
        <p:spPr>
          <a:xfrm>
            <a:off x="1587373" y="4241274"/>
            <a:ext cx="11118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u="sng" dirty="0"/>
              <a:t>Long exposure</a:t>
            </a:r>
            <a:endParaRPr lang="en-US" sz="1200" b="1" u="sng" dirty="0"/>
          </a:p>
        </p:txBody>
      </p:sp>
      <p:sp>
        <p:nvSpPr>
          <p:cNvPr id="124" name="TextBox 123"/>
          <p:cNvSpPr txBox="1"/>
          <p:nvPr/>
        </p:nvSpPr>
        <p:spPr>
          <a:xfrm>
            <a:off x="1519118" y="7761931"/>
            <a:ext cx="1151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u="sng" dirty="0"/>
              <a:t>Short exposure</a:t>
            </a:r>
            <a:endParaRPr lang="en-US" sz="1200" b="1" u="sng" dirty="0"/>
          </a:p>
        </p:txBody>
      </p:sp>
    </p:spTree>
    <p:extLst>
      <p:ext uri="{BB962C8B-B14F-4D97-AF65-F5344CB8AC3E}">
        <p14:creationId xmlns:p14="http://schemas.microsoft.com/office/powerpoint/2010/main" val="39580689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942750" y="641061"/>
            <a:ext cx="14378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/>
              <a:t>Figure S4A 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1584452" y="1512789"/>
            <a:ext cx="2270089" cy="143455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517323" y="1438806"/>
            <a:ext cx="354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180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508941" y="1594094"/>
            <a:ext cx="3632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14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08941" y="1802470"/>
            <a:ext cx="3822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10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516852" y="2032940"/>
            <a:ext cx="5000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75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523113" y="2335610"/>
            <a:ext cx="5000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6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508941" y="2761876"/>
            <a:ext cx="5000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45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608712" y="2137870"/>
            <a:ext cx="2245829" cy="3238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" name="Group 12"/>
          <p:cNvGrpSpPr/>
          <p:nvPr/>
        </p:nvGrpSpPr>
        <p:grpSpPr>
          <a:xfrm>
            <a:off x="892708" y="1572320"/>
            <a:ext cx="770220" cy="825892"/>
            <a:chOff x="561952" y="4922204"/>
            <a:chExt cx="1003585" cy="852215"/>
          </a:xfrm>
        </p:grpSpPr>
        <p:sp>
          <p:nvSpPr>
            <p:cNvPr id="59" name="TextBox 58"/>
            <p:cNvSpPr txBox="1"/>
            <p:nvPr/>
          </p:nvSpPr>
          <p:spPr>
            <a:xfrm>
              <a:off x="561952" y="5300702"/>
              <a:ext cx="764878" cy="2540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SREBP2</a:t>
              </a:r>
              <a:endParaRPr lang="en-US" sz="800" b="1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253903" y="4922204"/>
              <a:ext cx="311634" cy="1889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endParaRPr lang="en-US" sz="10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237788" y="5585450"/>
              <a:ext cx="297013" cy="1889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</a:t>
              </a:r>
              <a:endParaRPr lang="en-US" sz="1000" dirty="0"/>
            </a:p>
          </p:txBody>
        </p:sp>
        <p:sp>
          <p:nvSpPr>
            <p:cNvPr id="62" name="Left Bracket 61"/>
            <p:cNvSpPr/>
            <p:nvPr/>
          </p:nvSpPr>
          <p:spPr>
            <a:xfrm>
              <a:off x="1253666" y="5042244"/>
              <a:ext cx="62815" cy="655815"/>
            </a:xfrm>
            <a:prstGeom prst="leftBracket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</p:grpSp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3997530" y="1526276"/>
            <a:ext cx="2270089" cy="1421070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915880" y="146459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18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915880" y="162263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14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915880" y="185199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10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930052" y="206743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75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941528" y="237869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6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910543" y="277981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45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256553" y="2252322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U2AF65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256553" y="239189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Tubulin</a:t>
            </a:r>
          </a:p>
        </p:txBody>
      </p:sp>
      <p:grpSp>
        <p:nvGrpSpPr>
          <p:cNvPr id="23" name="Group 22"/>
          <p:cNvGrpSpPr/>
          <p:nvPr/>
        </p:nvGrpSpPr>
        <p:grpSpPr>
          <a:xfrm>
            <a:off x="1186437" y="1123628"/>
            <a:ext cx="2701395" cy="436946"/>
            <a:chOff x="503811" y="1470763"/>
            <a:chExt cx="2701395" cy="436946"/>
          </a:xfrm>
        </p:grpSpPr>
        <p:sp>
          <p:nvSpPr>
            <p:cNvPr id="46" name="TextBox 45"/>
            <p:cNvSpPr txBox="1"/>
            <p:nvPr/>
          </p:nvSpPr>
          <p:spPr>
            <a:xfrm>
              <a:off x="1107187" y="1692265"/>
              <a:ext cx="720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0         2        4</a:t>
              </a:r>
            </a:p>
          </p:txBody>
        </p:sp>
        <p:grpSp>
          <p:nvGrpSpPr>
            <p:cNvPr id="47" name="Group 46"/>
            <p:cNvGrpSpPr/>
            <p:nvPr/>
          </p:nvGrpSpPr>
          <p:grpSpPr>
            <a:xfrm>
              <a:off x="1171025" y="1479858"/>
              <a:ext cx="587959" cy="246221"/>
              <a:chOff x="1171025" y="1479858"/>
              <a:chExt cx="587959" cy="246221"/>
            </a:xfrm>
          </p:grpSpPr>
          <p:sp>
            <p:nvSpPr>
              <p:cNvPr id="57" name="TextBox 56"/>
              <p:cNvSpPr txBox="1"/>
              <p:nvPr/>
            </p:nvSpPr>
            <p:spPr>
              <a:xfrm>
                <a:off x="1189597" y="1479858"/>
                <a:ext cx="5693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5% CO</a:t>
                </a:r>
                <a:r>
                  <a:rPr lang="en-US" sz="1000" b="1" baseline="-25000" dirty="0"/>
                  <a:t>2</a:t>
                </a:r>
              </a:p>
            </p:txBody>
          </p:sp>
          <p:cxnSp>
            <p:nvCxnSpPr>
              <p:cNvPr id="58" name="Straight Connector 57"/>
              <p:cNvCxnSpPr/>
              <p:nvPr/>
            </p:nvCxnSpPr>
            <p:spPr>
              <a:xfrm>
                <a:off x="1171025" y="1712596"/>
                <a:ext cx="559903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8" name="TextBox 47"/>
            <p:cNvSpPr txBox="1"/>
            <p:nvPr/>
          </p:nvSpPr>
          <p:spPr>
            <a:xfrm>
              <a:off x="1913608" y="1487154"/>
              <a:ext cx="4988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NaOH</a:t>
              </a:r>
              <a:endParaRPr lang="en-US" sz="1200" b="1" baseline="-250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565075" y="1478165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1% CO</a:t>
              </a:r>
              <a:r>
                <a:rPr lang="en-US" sz="1000" b="1" baseline="-25000" dirty="0"/>
                <a:t>2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780287" y="1690572"/>
              <a:ext cx="720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0         2        4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485137" y="1690572"/>
              <a:ext cx="720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0         2        4</a:t>
              </a:r>
            </a:p>
          </p:txBody>
        </p:sp>
        <p:grpSp>
          <p:nvGrpSpPr>
            <p:cNvPr id="52" name="Group 51"/>
            <p:cNvGrpSpPr/>
            <p:nvPr/>
          </p:nvGrpSpPr>
          <p:grpSpPr>
            <a:xfrm>
              <a:off x="1862217" y="1470763"/>
              <a:ext cx="559903" cy="232738"/>
              <a:chOff x="1171025" y="1479858"/>
              <a:chExt cx="559903" cy="232738"/>
            </a:xfrm>
          </p:grpSpPr>
          <p:sp>
            <p:nvSpPr>
              <p:cNvPr id="55" name="TextBox 54"/>
              <p:cNvSpPr txBox="1"/>
              <p:nvPr/>
            </p:nvSpPr>
            <p:spPr>
              <a:xfrm>
                <a:off x="1189597" y="1479858"/>
                <a:ext cx="184731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US" sz="1000" b="1" baseline="-25000" dirty="0"/>
              </a:p>
            </p:txBody>
          </p:sp>
          <p:cxnSp>
            <p:nvCxnSpPr>
              <p:cNvPr id="56" name="Straight Connector 55"/>
              <p:cNvCxnSpPr/>
              <p:nvPr/>
            </p:nvCxnSpPr>
            <p:spPr>
              <a:xfrm>
                <a:off x="1171025" y="1712596"/>
                <a:ext cx="559903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53" name="Straight Connector 52"/>
            <p:cNvCxnSpPr/>
            <p:nvPr/>
          </p:nvCxnSpPr>
          <p:spPr>
            <a:xfrm>
              <a:off x="2564988" y="1697854"/>
              <a:ext cx="559903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503811" y="1711079"/>
              <a:ext cx="4507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Time (h)</a:t>
              </a: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4169600" y="1123628"/>
            <a:ext cx="2098019" cy="436946"/>
            <a:chOff x="1107187" y="1470763"/>
            <a:chExt cx="2098019" cy="436946"/>
          </a:xfrm>
        </p:grpSpPr>
        <p:sp>
          <p:nvSpPr>
            <p:cNvPr id="34" name="TextBox 33"/>
            <p:cNvSpPr txBox="1"/>
            <p:nvPr/>
          </p:nvSpPr>
          <p:spPr>
            <a:xfrm>
              <a:off x="1107187" y="1692265"/>
              <a:ext cx="720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0         2        4</a:t>
              </a:r>
            </a:p>
          </p:txBody>
        </p:sp>
        <p:grpSp>
          <p:nvGrpSpPr>
            <p:cNvPr id="35" name="Group 34"/>
            <p:cNvGrpSpPr/>
            <p:nvPr/>
          </p:nvGrpSpPr>
          <p:grpSpPr>
            <a:xfrm>
              <a:off x="1171025" y="1479858"/>
              <a:ext cx="587959" cy="246221"/>
              <a:chOff x="1171025" y="1479858"/>
              <a:chExt cx="587959" cy="246221"/>
            </a:xfrm>
          </p:grpSpPr>
          <p:sp>
            <p:nvSpPr>
              <p:cNvPr id="44" name="TextBox 43"/>
              <p:cNvSpPr txBox="1"/>
              <p:nvPr/>
            </p:nvSpPr>
            <p:spPr>
              <a:xfrm>
                <a:off x="1189597" y="1479858"/>
                <a:ext cx="5693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5% CO</a:t>
                </a:r>
                <a:r>
                  <a:rPr lang="en-US" sz="1000" b="1" baseline="-25000" dirty="0"/>
                  <a:t>2</a:t>
                </a:r>
              </a:p>
            </p:txBody>
          </p:sp>
          <p:cxnSp>
            <p:nvCxnSpPr>
              <p:cNvPr id="45" name="Straight Connector 44"/>
              <p:cNvCxnSpPr/>
              <p:nvPr/>
            </p:nvCxnSpPr>
            <p:spPr>
              <a:xfrm>
                <a:off x="1171025" y="1712596"/>
                <a:ext cx="559903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6" name="TextBox 35"/>
            <p:cNvSpPr txBox="1"/>
            <p:nvPr/>
          </p:nvSpPr>
          <p:spPr>
            <a:xfrm>
              <a:off x="1913608" y="1487154"/>
              <a:ext cx="4988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NaOH</a:t>
              </a:r>
              <a:endParaRPr lang="en-US" sz="1200" b="1" baseline="-250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565075" y="1478165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1% CO</a:t>
              </a:r>
              <a:r>
                <a:rPr lang="en-US" sz="1000" b="1" baseline="-25000" dirty="0"/>
                <a:t>2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780287" y="1690572"/>
              <a:ext cx="720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0         2        4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485137" y="1690572"/>
              <a:ext cx="720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0         2        4</a:t>
              </a:r>
            </a:p>
          </p:txBody>
        </p:sp>
        <p:grpSp>
          <p:nvGrpSpPr>
            <p:cNvPr id="40" name="Group 39"/>
            <p:cNvGrpSpPr/>
            <p:nvPr/>
          </p:nvGrpSpPr>
          <p:grpSpPr>
            <a:xfrm>
              <a:off x="1862217" y="1470763"/>
              <a:ext cx="559903" cy="232738"/>
              <a:chOff x="1171025" y="1479858"/>
              <a:chExt cx="559903" cy="232738"/>
            </a:xfrm>
          </p:grpSpPr>
          <p:sp>
            <p:nvSpPr>
              <p:cNvPr id="42" name="TextBox 41"/>
              <p:cNvSpPr txBox="1"/>
              <p:nvPr/>
            </p:nvSpPr>
            <p:spPr>
              <a:xfrm>
                <a:off x="1189597" y="1479858"/>
                <a:ext cx="184731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US" sz="1000" b="1" baseline="-25000" dirty="0"/>
              </a:p>
            </p:txBody>
          </p:sp>
          <p:cxnSp>
            <p:nvCxnSpPr>
              <p:cNvPr id="43" name="Straight Connector 42"/>
              <p:cNvCxnSpPr/>
              <p:nvPr/>
            </p:nvCxnSpPr>
            <p:spPr>
              <a:xfrm>
                <a:off x="1171025" y="1712596"/>
                <a:ext cx="559903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41" name="Straight Connector 40"/>
            <p:cNvCxnSpPr/>
            <p:nvPr/>
          </p:nvCxnSpPr>
          <p:spPr>
            <a:xfrm>
              <a:off x="2564988" y="1697854"/>
              <a:ext cx="559903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5" name="Rectangle 24"/>
          <p:cNvSpPr/>
          <p:nvPr/>
        </p:nvSpPr>
        <p:spPr>
          <a:xfrm>
            <a:off x="4035581" y="2263026"/>
            <a:ext cx="2255983" cy="1872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endParaRPr lang="en-US" sz="1000" dirty="0"/>
          </a:p>
          <a:p>
            <a:pPr algn="ctr"/>
            <a:r>
              <a:rPr lang="en-US" sz="1000" dirty="0"/>
              <a:t>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427AE40-B4E4-8652-10D5-479C7720CE6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H="1">
            <a:off x="1576300" y="3350060"/>
            <a:ext cx="2273804" cy="1467448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77CE0E20-9680-E944-E5C4-843B5456B3F8}"/>
              </a:ext>
            </a:extLst>
          </p:cNvPr>
          <p:cNvSpPr txBox="1"/>
          <p:nvPr/>
        </p:nvSpPr>
        <p:spPr>
          <a:xfrm>
            <a:off x="1483673" y="3278994"/>
            <a:ext cx="354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18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215A44D-E308-D056-6531-8283B635861B}"/>
              </a:ext>
            </a:extLst>
          </p:cNvPr>
          <p:cNvSpPr txBox="1"/>
          <p:nvPr/>
        </p:nvSpPr>
        <p:spPr>
          <a:xfrm>
            <a:off x="1475291" y="3434282"/>
            <a:ext cx="3632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14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D65B4F8-EC24-1EA0-4950-45FFA548B389}"/>
              </a:ext>
            </a:extLst>
          </p:cNvPr>
          <p:cNvSpPr txBox="1"/>
          <p:nvPr/>
        </p:nvSpPr>
        <p:spPr>
          <a:xfrm>
            <a:off x="1475291" y="3642658"/>
            <a:ext cx="3822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10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181C4FE-35AA-F170-BDC5-05B8BC1A92FD}"/>
              </a:ext>
            </a:extLst>
          </p:cNvPr>
          <p:cNvSpPr txBox="1"/>
          <p:nvPr/>
        </p:nvSpPr>
        <p:spPr>
          <a:xfrm>
            <a:off x="1483202" y="3873128"/>
            <a:ext cx="5000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75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3A922A8-5388-3F8C-7A68-ED5BAA688240}"/>
              </a:ext>
            </a:extLst>
          </p:cNvPr>
          <p:cNvSpPr txBox="1"/>
          <p:nvPr/>
        </p:nvSpPr>
        <p:spPr>
          <a:xfrm>
            <a:off x="1489463" y="4175798"/>
            <a:ext cx="5000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60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8EAA8E76-E415-97FA-B795-D036B965CCEA}"/>
              </a:ext>
            </a:extLst>
          </p:cNvPr>
          <p:cNvSpPr/>
          <p:nvPr/>
        </p:nvSpPr>
        <p:spPr>
          <a:xfrm>
            <a:off x="1593119" y="3441243"/>
            <a:ext cx="2254141" cy="2510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33AC3B3-2B46-2F6A-042F-BB00D57D82D6}"/>
              </a:ext>
            </a:extLst>
          </p:cNvPr>
          <p:cNvSpPr txBox="1"/>
          <p:nvPr/>
        </p:nvSpPr>
        <p:spPr>
          <a:xfrm>
            <a:off x="1475291" y="4593438"/>
            <a:ext cx="5000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FF00"/>
                </a:solidFill>
              </a:rPr>
              <a:t>45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E24AF47-5227-E826-35AC-DD50D38730FF}"/>
              </a:ext>
            </a:extLst>
          </p:cNvPr>
          <p:cNvSpPr txBox="1"/>
          <p:nvPr/>
        </p:nvSpPr>
        <p:spPr>
          <a:xfrm>
            <a:off x="2224144" y="2902200"/>
            <a:ext cx="11118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u="sng" dirty="0"/>
              <a:t>Long exposure</a:t>
            </a:r>
            <a:endParaRPr lang="en-US" sz="1200" b="1" u="sng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A454358-6BCC-1175-900C-F9E05B7B219A}"/>
              </a:ext>
            </a:extLst>
          </p:cNvPr>
          <p:cNvSpPr txBox="1"/>
          <p:nvPr/>
        </p:nvSpPr>
        <p:spPr>
          <a:xfrm>
            <a:off x="2184069" y="4849869"/>
            <a:ext cx="1151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u="sng" dirty="0"/>
              <a:t>Short exposure</a:t>
            </a:r>
            <a:endParaRPr lang="en-US" sz="1200" b="1" u="sng" dirty="0"/>
          </a:p>
        </p:txBody>
      </p:sp>
      <p:grpSp>
        <p:nvGrpSpPr>
          <p:cNvPr id="65" name="Group 64">
            <a:extLst>
              <a:ext uri="{FF2B5EF4-FFF2-40B4-BE49-F238E27FC236}">
                <a16:creationId xmlns:a16="http://schemas.microsoft.com/office/drawing/2014/main" id="{2035AB2F-7DCE-086D-FC1F-33DC6E6B7652}"/>
              </a:ext>
            </a:extLst>
          </p:cNvPr>
          <p:cNvGrpSpPr/>
          <p:nvPr/>
        </p:nvGrpSpPr>
        <p:grpSpPr>
          <a:xfrm>
            <a:off x="787835" y="3425435"/>
            <a:ext cx="770220" cy="825892"/>
            <a:chOff x="561952" y="4922204"/>
            <a:chExt cx="1003585" cy="852215"/>
          </a:xfrm>
        </p:grpSpPr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B5E27072-4F34-9D9B-3422-6895B2ED40EF}"/>
                </a:ext>
              </a:extLst>
            </p:cNvPr>
            <p:cNvSpPr txBox="1"/>
            <p:nvPr/>
          </p:nvSpPr>
          <p:spPr>
            <a:xfrm>
              <a:off x="561952" y="5300702"/>
              <a:ext cx="764878" cy="2540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SREBP2</a:t>
              </a:r>
              <a:endParaRPr lang="en-US" sz="800" b="1" dirty="0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FF7DF23D-8B7E-E17B-3677-5A46E195C09F}"/>
                </a:ext>
              </a:extLst>
            </p:cNvPr>
            <p:cNvSpPr txBox="1"/>
            <p:nvPr/>
          </p:nvSpPr>
          <p:spPr>
            <a:xfrm>
              <a:off x="1253903" y="4922204"/>
              <a:ext cx="311634" cy="1889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endParaRPr lang="en-US" sz="1000" dirty="0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E5A77914-2E87-B37A-C197-F20CF5D018D7}"/>
                </a:ext>
              </a:extLst>
            </p:cNvPr>
            <p:cNvSpPr txBox="1"/>
            <p:nvPr/>
          </p:nvSpPr>
          <p:spPr>
            <a:xfrm>
              <a:off x="1237788" y="5585450"/>
              <a:ext cx="297013" cy="1889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</a:t>
              </a:r>
              <a:endParaRPr lang="en-US" sz="1000" dirty="0"/>
            </a:p>
          </p:txBody>
        </p:sp>
        <p:sp>
          <p:nvSpPr>
            <p:cNvPr id="69" name="Left Bracket 68">
              <a:extLst>
                <a:ext uri="{FF2B5EF4-FFF2-40B4-BE49-F238E27FC236}">
                  <a16:creationId xmlns:a16="http://schemas.microsoft.com/office/drawing/2014/main" id="{170DE2BA-7FDC-81FC-4263-45C437264BC6}"/>
                </a:ext>
              </a:extLst>
            </p:cNvPr>
            <p:cNvSpPr/>
            <p:nvPr/>
          </p:nvSpPr>
          <p:spPr>
            <a:xfrm>
              <a:off x="1253666" y="5042244"/>
              <a:ext cx="62815" cy="655815"/>
            </a:xfrm>
            <a:prstGeom prst="leftBracket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</p:grpSp>
    </p:spTree>
    <p:extLst>
      <p:ext uri="{BB962C8B-B14F-4D97-AF65-F5344CB8AC3E}">
        <p14:creationId xmlns:p14="http://schemas.microsoft.com/office/powerpoint/2010/main" val="16001195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2"/>
          <a:srcRect r="46015"/>
          <a:stretch/>
        </p:blipFill>
        <p:spPr>
          <a:xfrm>
            <a:off x="1440538" y="4481865"/>
            <a:ext cx="1856998" cy="2599400"/>
          </a:xfrm>
          <a:prstGeom prst="rect">
            <a:avLst/>
          </a:prstGeom>
        </p:spPr>
      </p:pic>
      <p:pic>
        <p:nvPicPr>
          <p:cNvPr id="97" name="Picture 96"/>
          <p:cNvPicPr>
            <a:picLocks noChangeAspect="1"/>
          </p:cNvPicPr>
          <p:nvPr/>
        </p:nvPicPr>
        <p:blipFill rotWithShape="1">
          <a:blip r:embed="rId3"/>
          <a:srcRect b="2384"/>
          <a:stretch/>
        </p:blipFill>
        <p:spPr>
          <a:xfrm>
            <a:off x="3756756" y="1477503"/>
            <a:ext cx="1746877" cy="2606910"/>
          </a:xfrm>
          <a:prstGeom prst="rect">
            <a:avLst/>
          </a:prstGeom>
        </p:spPr>
      </p:pic>
      <p:sp>
        <p:nvSpPr>
          <p:cNvPr id="98" name="TextBox 97"/>
          <p:cNvSpPr txBox="1"/>
          <p:nvPr/>
        </p:nvSpPr>
        <p:spPr>
          <a:xfrm>
            <a:off x="113720" y="680590"/>
            <a:ext cx="9824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/>
              <a:t>Figure S6B </a:t>
            </a:r>
          </a:p>
        </p:txBody>
      </p:sp>
      <p:sp>
        <p:nvSpPr>
          <p:cNvPr id="99" name="Rectangle 98"/>
          <p:cNvSpPr/>
          <p:nvPr/>
        </p:nvSpPr>
        <p:spPr>
          <a:xfrm>
            <a:off x="3830420" y="3249838"/>
            <a:ext cx="1656561" cy="3275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/>
          </a:p>
        </p:txBody>
      </p:sp>
      <p:pic>
        <p:nvPicPr>
          <p:cNvPr id="130" name="Picture 129"/>
          <p:cNvPicPr>
            <a:picLocks noChangeAspect="1"/>
          </p:cNvPicPr>
          <p:nvPr/>
        </p:nvPicPr>
        <p:blipFill rotWithShape="1">
          <a:blip r:embed="rId4"/>
          <a:srcRect r="46815"/>
          <a:stretch/>
        </p:blipFill>
        <p:spPr>
          <a:xfrm>
            <a:off x="1547747" y="1482993"/>
            <a:ext cx="1913589" cy="2602905"/>
          </a:xfrm>
          <a:prstGeom prst="rect">
            <a:avLst/>
          </a:prstGeom>
        </p:spPr>
      </p:pic>
      <p:sp>
        <p:nvSpPr>
          <p:cNvPr id="131" name="Rectangle 130"/>
          <p:cNvSpPr/>
          <p:nvPr/>
        </p:nvSpPr>
        <p:spPr>
          <a:xfrm>
            <a:off x="1465971" y="4815395"/>
            <a:ext cx="1831565" cy="3360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/>
          </a:p>
        </p:txBody>
      </p:sp>
      <p:sp>
        <p:nvSpPr>
          <p:cNvPr id="132" name="Rectangle 131"/>
          <p:cNvSpPr/>
          <p:nvPr/>
        </p:nvSpPr>
        <p:spPr>
          <a:xfrm>
            <a:off x="1545080" y="3185438"/>
            <a:ext cx="1913590" cy="332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/>
          </a:p>
        </p:txBody>
      </p:sp>
      <p:cxnSp>
        <p:nvCxnSpPr>
          <p:cNvPr id="101" name="Straight Connector 100"/>
          <p:cNvCxnSpPr/>
          <p:nvPr/>
        </p:nvCxnSpPr>
        <p:spPr>
          <a:xfrm>
            <a:off x="1898474" y="1257103"/>
            <a:ext cx="55138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1898474" y="990099"/>
            <a:ext cx="5616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MBCD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2752785" y="996120"/>
            <a:ext cx="412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O</a:t>
            </a:r>
            <a:r>
              <a:rPr lang="en-US" sz="1100" baseline="-25000" dirty="0"/>
              <a:t>2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1943032" y="1237898"/>
            <a:ext cx="135533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-          +         5%    1%</a:t>
            </a:r>
          </a:p>
        </p:txBody>
      </p:sp>
      <p:cxnSp>
        <p:nvCxnSpPr>
          <p:cNvPr id="105" name="Straight Connector 104"/>
          <p:cNvCxnSpPr/>
          <p:nvPr/>
        </p:nvCxnSpPr>
        <p:spPr>
          <a:xfrm>
            <a:off x="2701771" y="1266956"/>
            <a:ext cx="55138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>
            <a:off x="3973328" y="1249351"/>
            <a:ext cx="55138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7" name="TextBox 106"/>
          <p:cNvSpPr txBox="1"/>
          <p:nvPr/>
        </p:nvSpPr>
        <p:spPr>
          <a:xfrm>
            <a:off x="3962738" y="991825"/>
            <a:ext cx="5616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MBCD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4827638" y="988367"/>
            <a:ext cx="412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O</a:t>
            </a:r>
            <a:r>
              <a:rPr lang="en-US" sz="1100" baseline="-25000" dirty="0"/>
              <a:t>2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3943079" y="1244315"/>
            <a:ext cx="13864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-            +      5%      1%</a:t>
            </a:r>
          </a:p>
        </p:txBody>
      </p:sp>
      <p:cxnSp>
        <p:nvCxnSpPr>
          <p:cNvPr id="110" name="Straight Connector 109"/>
          <p:cNvCxnSpPr/>
          <p:nvPr/>
        </p:nvCxnSpPr>
        <p:spPr>
          <a:xfrm>
            <a:off x="4787215" y="1249725"/>
            <a:ext cx="55138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grpSp>
        <p:nvGrpSpPr>
          <p:cNvPr id="111" name="Group 110"/>
          <p:cNvGrpSpPr/>
          <p:nvPr/>
        </p:nvGrpSpPr>
        <p:grpSpPr>
          <a:xfrm>
            <a:off x="596200" y="1956127"/>
            <a:ext cx="1002563" cy="1517801"/>
            <a:chOff x="788358" y="1917616"/>
            <a:chExt cx="1202263" cy="2033564"/>
          </a:xfrm>
        </p:grpSpPr>
        <p:sp>
          <p:nvSpPr>
            <p:cNvPr id="126" name="TextBox 125"/>
            <p:cNvSpPr txBox="1"/>
            <p:nvPr/>
          </p:nvSpPr>
          <p:spPr>
            <a:xfrm>
              <a:off x="788358" y="2757147"/>
              <a:ext cx="806957" cy="3505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SREBP2 </a:t>
              </a:r>
            </a:p>
          </p:txBody>
        </p:sp>
        <p:sp>
          <p:nvSpPr>
            <p:cNvPr id="127" name="Left Bracket 126"/>
            <p:cNvSpPr/>
            <p:nvPr/>
          </p:nvSpPr>
          <p:spPr>
            <a:xfrm>
              <a:off x="1614110" y="2051855"/>
              <a:ext cx="116871" cy="1703884"/>
            </a:xfrm>
            <a:prstGeom prst="leftBracket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1657124" y="1917616"/>
              <a:ext cx="318309" cy="3505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1691936" y="3600673"/>
              <a:ext cx="298685" cy="3505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c</a:t>
              </a:r>
            </a:p>
          </p:txBody>
        </p:sp>
      </p:grpSp>
      <p:grpSp>
        <p:nvGrpSpPr>
          <p:cNvPr id="112" name="Group 111"/>
          <p:cNvGrpSpPr/>
          <p:nvPr/>
        </p:nvGrpSpPr>
        <p:grpSpPr>
          <a:xfrm>
            <a:off x="1395563" y="4625337"/>
            <a:ext cx="532107" cy="2043800"/>
            <a:chOff x="6015668" y="1168374"/>
            <a:chExt cx="638092" cy="2738300"/>
          </a:xfrm>
        </p:grpSpPr>
        <p:sp>
          <p:nvSpPr>
            <p:cNvPr id="121" name="TextBox 120"/>
            <p:cNvSpPr txBox="1"/>
            <p:nvPr/>
          </p:nvSpPr>
          <p:spPr>
            <a:xfrm>
              <a:off x="6015668" y="1168374"/>
              <a:ext cx="594116" cy="3505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170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6018789" y="1558659"/>
              <a:ext cx="565881" cy="5773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130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6074397" y="2314374"/>
              <a:ext cx="565879" cy="5773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100</a:t>
              </a: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6074945" y="2935271"/>
              <a:ext cx="467672" cy="350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70</a:t>
              </a: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6087878" y="3556167"/>
              <a:ext cx="565882" cy="350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55</a:t>
              </a:r>
            </a:p>
          </p:txBody>
        </p:sp>
      </p:grpSp>
      <p:grpSp>
        <p:nvGrpSpPr>
          <p:cNvPr id="113" name="Group 112"/>
          <p:cNvGrpSpPr/>
          <p:nvPr/>
        </p:nvGrpSpPr>
        <p:grpSpPr>
          <a:xfrm>
            <a:off x="3663738" y="1397076"/>
            <a:ext cx="507443" cy="2422234"/>
            <a:chOff x="6007278" y="1168374"/>
            <a:chExt cx="608526" cy="3245329"/>
          </a:xfrm>
        </p:grpSpPr>
        <p:sp>
          <p:nvSpPr>
            <p:cNvPr id="116" name="TextBox 115"/>
            <p:cNvSpPr txBox="1"/>
            <p:nvPr/>
          </p:nvSpPr>
          <p:spPr>
            <a:xfrm>
              <a:off x="6015666" y="1168374"/>
              <a:ext cx="594115" cy="3505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170</a:t>
              </a: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6007278" y="1703030"/>
              <a:ext cx="565884" cy="5773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130</a:t>
              </a: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6007279" y="2535058"/>
              <a:ext cx="565885" cy="5773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100</a:t>
              </a: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6036712" y="3275024"/>
              <a:ext cx="565884" cy="350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70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6049920" y="4063196"/>
              <a:ext cx="565884" cy="350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55</a:t>
              </a:r>
            </a:p>
          </p:txBody>
        </p:sp>
      </p:grpSp>
      <p:sp>
        <p:nvSpPr>
          <p:cNvPr id="114" name="TextBox 113"/>
          <p:cNvSpPr txBox="1"/>
          <p:nvPr/>
        </p:nvSpPr>
        <p:spPr>
          <a:xfrm>
            <a:off x="5441083" y="3363678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U2AF65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5441083" y="3609091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Tubulin</a:t>
            </a:r>
          </a:p>
        </p:txBody>
      </p:sp>
      <p:grpSp>
        <p:nvGrpSpPr>
          <p:cNvPr id="66" name="Group 65"/>
          <p:cNvGrpSpPr/>
          <p:nvPr/>
        </p:nvGrpSpPr>
        <p:grpSpPr>
          <a:xfrm>
            <a:off x="393000" y="4889827"/>
            <a:ext cx="1002563" cy="1517801"/>
            <a:chOff x="788358" y="1917616"/>
            <a:chExt cx="1202263" cy="2033564"/>
          </a:xfrm>
        </p:grpSpPr>
        <p:sp>
          <p:nvSpPr>
            <p:cNvPr id="67" name="TextBox 66"/>
            <p:cNvSpPr txBox="1"/>
            <p:nvPr/>
          </p:nvSpPr>
          <p:spPr>
            <a:xfrm>
              <a:off x="788358" y="2757147"/>
              <a:ext cx="806957" cy="3505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SREBP2 </a:t>
              </a:r>
            </a:p>
          </p:txBody>
        </p:sp>
        <p:sp>
          <p:nvSpPr>
            <p:cNvPr id="68" name="Left Bracket 67"/>
            <p:cNvSpPr/>
            <p:nvPr/>
          </p:nvSpPr>
          <p:spPr>
            <a:xfrm>
              <a:off x="1614110" y="2051855"/>
              <a:ext cx="116871" cy="1703884"/>
            </a:xfrm>
            <a:prstGeom prst="leftBracket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657124" y="1917616"/>
              <a:ext cx="318309" cy="3505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1691936" y="3600673"/>
              <a:ext cx="298685" cy="3505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c</a:t>
              </a:r>
            </a:p>
          </p:txBody>
        </p:sp>
      </p:grpSp>
      <p:sp>
        <p:nvSpPr>
          <p:cNvPr id="71" name="TextBox 70"/>
          <p:cNvSpPr txBox="1"/>
          <p:nvPr/>
        </p:nvSpPr>
        <p:spPr>
          <a:xfrm>
            <a:off x="1796716" y="4053994"/>
            <a:ext cx="11118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u="sng" dirty="0"/>
              <a:t>Long exposure</a:t>
            </a:r>
            <a:endParaRPr lang="en-US" sz="1200" b="1" u="sng" dirty="0"/>
          </a:p>
        </p:txBody>
      </p:sp>
      <p:sp>
        <p:nvSpPr>
          <p:cNvPr id="72" name="TextBox 71"/>
          <p:cNvSpPr txBox="1"/>
          <p:nvPr/>
        </p:nvSpPr>
        <p:spPr>
          <a:xfrm>
            <a:off x="1825544" y="7081543"/>
            <a:ext cx="1151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u="sng" dirty="0"/>
              <a:t>Short exposure</a:t>
            </a:r>
            <a:endParaRPr lang="en-US" sz="1200" b="1" u="sng" dirty="0"/>
          </a:p>
        </p:txBody>
      </p:sp>
      <p:grpSp>
        <p:nvGrpSpPr>
          <p:cNvPr id="73" name="Group 72"/>
          <p:cNvGrpSpPr/>
          <p:nvPr/>
        </p:nvGrpSpPr>
        <p:grpSpPr>
          <a:xfrm>
            <a:off x="1420871" y="1630042"/>
            <a:ext cx="532107" cy="2043800"/>
            <a:chOff x="6015668" y="1168374"/>
            <a:chExt cx="638092" cy="2738300"/>
          </a:xfrm>
        </p:grpSpPr>
        <p:sp>
          <p:nvSpPr>
            <p:cNvPr id="74" name="TextBox 73"/>
            <p:cNvSpPr txBox="1"/>
            <p:nvPr/>
          </p:nvSpPr>
          <p:spPr>
            <a:xfrm>
              <a:off x="6015668" y="1168374"/>
              <a:ext cx="594116" cy="3505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170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6018789" y="1558659"/>
              <a:ext cx="565881" cy="5773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130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6074397" y="2314374"/>
              <a:ext cx="565879" cy="5773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100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6074945" y="2935271"/>
              <a:ext cx="467672" cy="350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70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6087878" y="3556167"/>
              <a:ext cx="565882" cy="350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5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343999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228528" y="687029"/>
            <a:ext cx="4036877" cy="3352607"/>
            <a:chOff x="7480994" y="380418"/>
            <a:chExt cx="4962915" cy="4072087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951616" y="992852"/>
              <a:ext cx="2721842" cy="3459653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11710277" y="3730395"/>
              <a:ext cx="723650" cy="2990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Tubulin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480994" y="2290814"/>
              <a:ext cx="1206478" cy="3177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SREBP2 (Flag)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8951616" y="2444304"/>
              <a:ext cx="2721843" cy="71817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7" name="Rectangle 6"/>
            <p:cNvSpPr/>
            <p:nvPr/>
          </p:nvSpPr>
          <p:spPr>
            <a:xfrm>
              <a:off x="8982651" y="3288877"/>
              <a:ext cx="2690807" cy="44603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8" name="Rectangle 7"/>
            <p:cNvSpPr/>
            <p:nvPr/>
          </p:nvSpPr>
          <p:spPr>
            <a:xfrm>
              <a:off x="8951616" y="1320724"/>
              <a:ext cx="2690807" cy="57243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8816636" y="983017"/>
              <a:ext cx="755555" cy="3043044"/>
              <a:chOff x="5958974" y="1132806"/>
              <a:chExt cx="755555" cy="3043044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5984545" y="1132806"/>
                <a:ext cx="493076" cy="3177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solidFill>
                      <a:srgbClr val="FFFF00"/>
                    </a:solidFill>
                  </a:rPr>
                  <a:t>170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6009120" y="1609342"/>
                <a:ext cx="661004" cy="3177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FFFF00"/>
                    </a:solidFill>
                  </a:rPr>
                  <a:t>130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6012729" y="2392777"/>
                <a:ext cx="701800" cy="3177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FFFF00"/>
                    </a:solidFill>
                  </a:rPr>
                  <a:t>100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5958974" y="3135905"/>
                <a:ext cx="467671" cy="3738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solidFill>
                      <a:srgbClr val="FFFF00"/>
                    </a:solidFill>
                  </a:rPr>
                  <a:t>70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6020028" y="3858098"/>
                <a:ext cx="467673" cy="3177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FFFF00"/>
                    </a:solidFill>
                  </a:rPr>
                  <a:t>55</a:t>
                </a: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11704493" y="3431335"/>
              <a:ext cx="739416" cy="2990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U2AF65</a:t>
              </a:r>
            </a:p>
          </p:txBody>
        </p:sp>
        <p:sp>
          <p:nvSpPr>
            <p:cNvPr id="11" name="Left Bracket 10"/>
            <p:cNvSpPr/>
            <p:nvPr/>
          </p:nvSpPr>
          <p:spPr>
            <a:xfrm>
              <a:off x="8654603" y="1822654"/>
              <a:ext cx="45719" cy="1243302"/>
            </a:xfrm>
            <a:prstGeom prst="leftBracket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8645883" y="1630786"/>
              <a:ext cx="319652" cy="3177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645317" y="2846941"/>
              <a:ext cx="299945" cy="3177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c</a:t>
              </a:r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9204830" y="380418"/>
              <a:ext cx="2319091" cy="685385"/>
              <a:chOff x="9204830" y="380418"/>
              <a:chExt cx="2319091" cy="685385"/>
            </a:xfrm>
          </p:grpSpPr>
          <p:cxnSp>
            <p:nvCxnSpPr>
              <p:cNvPr id="15" name="Straight Connector 14"/>
              <p:cNvCxnSpPr/>
              <p:nvPr/>
            </p:nvCxnSpPr>
            <p:spPr>
              <a:xfrm>
                <a:off x="9713617" y="739838"/>
                <a:ext cx="661213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9776247" y="389006"/>
                <a:ext cx="800508" cy="3738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MBCD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0773968" y="397352"/>
                <a:ext cx="566307" cy="3738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CO</a:t>
                </a:r>
                <a:r>
                  <a:rPr lang="en-US" sz="1400" b="1" baseline="-25000" dirty="0"/>
                  <a:t>2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9678930" y="729359"/>
                <a:ext cx="1844991" cy="336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-          +         5%    1%</a:t>
                </a:r>
              </a:p>
            </p:txBody>
          </p:sp>
          <p:cxnSp>
            <p:nvCxnSpPr>
              <p:cNvPr id="19" name="Straight Connector 18"/>
              <p:cNvCxnSpPr/>
              <p:nvPr/>
            </p:nvCxnSpPr>
            <p:spPr>
              <a:xfrm>
                <a:off x="10676922" y="753039"/>
                <a:ext cx="661213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9204830" y="380418"/>
                <a:ext cx="481252" cy="3738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NT</a:t>
                </a:r>
              </a:p>
            </p:txBody>
          </p:sp>
          <p:cxnSp>
            <p:nvCxnSpPr>
              <p:cNvPr id="21" name="Straight Connector 20"/>
              <p:cNvCxnSpPr/>
              <p:nvPr/>
            </p:nvCxnSpPr>
            <p:spPr>
              <a:xfrm>
                <a:off x="9259910" y="739838"/>
                <a:ext cx="30846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7" name="TextBox 26"/>
          <p:cNvSpPr txBox="1"/>
          <p:nvPr/>
        </p:nvSpPr>
        <p:spPr>
          <a:xfrm>
            <a:off x="876867" y="599473"/>
            <a:ext cx="10637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/>
              <a:t>Figure S6C </a:t>
            </a:r>
          </a:p>
        </p:txBody>
      </p:sp>
    </p:spTree>
    <p:extLst>
      <p:ext uri="{BB962C8B-B14F-4D97-AF65-F5344CB8AC3E}">
        <p14:creationId xmlns:p14="http://schemas.microsoft.com/office/powerpoint/2010/main" val="11853082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3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8400" y="2192110"/>
            <a:ext cx="2362184" cy="2286703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26703" y="2192110"/>
            <a:ext cx="2326358" cy="2286703"/>
          </a:xfrm>
          <a:prstGeom prst="rect">
            <a:avLst/>
          </a:prstGeom>
        </p:spPr>
      </p:pic>
      <p:sp>
        <p:nvSpPr>
          <p:cNvPr id="42" name="Rectangle 41"/>
          <p:cNvSpPr/>
          <p:nvPr/>
        </p:nvSpPr>
        <p:spPr>
          <a:xfrm>
            <a:off x="1143856" y="3743014"/>
            <a:ext cx="2386728" cy="4093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43" name="Rectangle 42"/>
          <p:cNvSpPr/>
          <p:nvPr/>
        </p:nvSpPr>
        <p:spPr>
          <a:xfrm>
            <a:off x="3826703" y="3832369"/>
            <a:ext cx="2326358" cy="2840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grpSp>
        <p:nvGrpSpPr>
          <p:cNvPr id="4" name="Group 3"/>
          <p:cNvGrpSpPr/>
          <p:nvPr/>
        </p:nvGrpSpPr>
        <p:grpSpPr>
          <a:xfrm>
            <a:off x="1532974" y="1503505"/>
            <a:ext cx="1851148" cy="754588"/>
            <a:chOff x="3241355" y="1547918"/>
            <a:chExt cx="2107867" cy="858184"/>
          </a:xfrm>
        </p:grpSpPr>
        <p:sp>
          <p:nvSpPr>
            <p:cNvPr id="35" name="TextBox 34"/>
            <p:cNvSpPr txBox="1"/>
            <p:nvPr/>
          </p:nvSpPr>
          <p:spPr>
            <a:xfrm rot="16200000">
              <a:off x="3083283" y="1946055"/>
              <a:ext cx="596511" cy="280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DMSO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3602473" y="1853721"/>
              <a:ext cx="824395" cy="280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Fatostatin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4277652" y="1912264"/>
              <a:ext cx="596511" cy="280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DMSO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4796841" y="1819932"/>
              <a:ext cx="824395" cy="280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Fatostatin</a:t>
              </a:r>
            </a:p>
          </p:txBody>
        </p:sp>
      </p:grpSp>
      <p:cxnSp>
        <p:nvCxnSpPr>
          <p:cNvPr id="5" name="Straight Connector 4"/>
          <p:cNvCxnSpPr/>
          <p:nvPr/>
        </p:nvCxnSpPr>
        <p:spPr>
          <a:xfrm>
            <a:off x="1564135" y="1512466"/>
            <a:ext cx="769604" cy="750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2595811" y="1508715"/>
            <a:ext cx="769604" cy="750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587904" y="1225321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5% CO</a:t>
            </a:r>
            <a:r>
              <a:rPr lang="en-US" sz="1000" b="1" baseline="-25000" dirty="0"/>
              <a:t>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612645" y="1179746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1% CO</a:t>
            </a:r>
            <a:r>
              <a:rPr lang="en-US" sz="1000" b="1" baseline="-25000" dirty="0"/>
              <a:t>2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4120529" y="1485927"/>
            <a:ext cx="1851148" cy="754588"/>
            <a:chOff x="3241355" y="1547918"/>
            <a:chExt cx="2107867" cy="858184"/>
          </a:xfrm>
        </p:grpSpPr>
        <p:sp>
          <p:nvSpPr>
            <p:cNvPr id="31" name="TextBox 30"/>
            <p:cNvSpPr txBox="1"/>
            <p:nvPr/>
          </p:nvSpPr>
          <p:spPr>
            <a:xfrm rot="16200000">
              <a:off x="3083283" y="1946055"/>
              <a:ext cx="596511" cy="280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DMSO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 rot="16200000">
              <a:off x="3602473" y="1853721"/>
              <a:ext cx="824395" cy="280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Fatostatin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4277652" y="1912264"/>
              <a:ext cx="596511" cy="280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DMSO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4796841" y="1819932"/>
              <a:ext cx="824395" cy="280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Fatostatin</a:t>
              </a:r>
            </a:p>
          </p:txBody>
        </p:sp>
      </p:grpSp>
      <p:cxnSp>
        <p:nvCxnSpPr>
          <p:cNvPr id="10" name="Straight Connector 9"/>
          <p:cNvCxnSpPr/>
          <p:nvPr/>
        </p:nvCxnSpPr>
        <p:spPr>
          <a:xfrm>
            <a:off x="4151690" y="1494889"/>
            <a:ext cx="769604" cy="750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5183366" y="1491138"/>
            <a:ext cx="769604" cy="750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175459" y="1207743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5% CO</a:t>
            </a:r>
            <a:r>
              <a:rPr lang="en-US" sz="1000" b="1" baseline="-25000" dirty="0"/>
              <a:t>2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200202" y="1162168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1% CO</a:t>
            </a:r>
            <a:r>
              <a:rPr lang="en-US" sz="1000" b="1" baseline="-25000" dirty="0"/>
              <a:t>2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133977" y="2220163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FF00"/>
                </a:solidFill>
              </a:rPr>
              <a:t>17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092382" y="2485626"/>
            <a:ext cx="4107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FF00"/>
                </a:solidFill>
              </a:rPr>
              <a:t>13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092382" y="3091900"/>
            <a:ext cx="4107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FF00"/>
                </a:solidFill>
              </a:rPr>
              <a:t>10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101151" y="3706977"/>
            <a:ext cx="4107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FF00"/>
                </a:solidFill>
              </a:rPr>
              <a:t>7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74931" y="4200274"/>
            <a:ext cx="4107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FF00"/>
                </a:solidFill>
              </a:rPr>
              <a:t>55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782572" y="223662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FF00"/>
                </a:solidFill>
              </a:rPr>
              <a:t>17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761774" y="2463657"/>
            <a:ext cx="4107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FF00"/>
                </a:solidFill>
              </a:rPr>
              <a:t>13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763240" y="3067098"/>
            <a:ext cx="4107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FF00"/>
                </a:solidFill>
              </a:rPr>
              <a:t>100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782572" y="3726716"/>
            <a:ext cx="4107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FF00"/>
                </a:solidFill>
              </a:rPr>
              <a:t>70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744825" y="4200274"/>
            <a:ext cx="4107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FF00"/>
                </a:solidFill>
              </a:rPr>
              <a:t>55</a:t>
            </a:r>
          </a:p>
        </p:txBody>
      </p:sp>
      <p:grpSp>
        <p:nvGrpSpPr>
          <p:cNvPr id="24" name="Group 23"/>
          <p:cNvGrpSpPr/>
          <p:nvPr/>
        </p:nvGrpSpPr>
        <p:grpSpPr>
          <a:xfrm>
            <a:off x="197271" y="2436378"/>
            <a:ext cx="990116" cy="1635862"/>
            <a:chOff x="737264" y="1917616"/>
            <a:chExt cx="1127426" cy="1860445"/>
          </a:xfrm>
        </p:grpSpPr>
        <p:sp>
          <p:nvSpPr>
            <p:cNvPr id="27" name="TextBox 26"/>
            <p:cNvSpPr txBox="1"/>
            <p:nvPr/>
          </p:nvSpPr>
          <p:spPr>
            <a:xfrm>
              <a:off x="737264" y="2700828"/>
              <a:ext cx="734139" cy="2975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SREBP2</a:t>
              </a:r>
              <a:r>
                <a:rPr lang="en-US" sz="1000" b="1" dirty="0"/>
                <a:t> </a:t>
              </a:r>
            </a:p>
          </p:txBody>
        </p:sp>
        <p:sp>
          <p:nvSpPr>
            <p:cNvPr id="28" name="Left Bracket 27"/>
            <p:cNvSpPr/>
            <p:nvPr/>
          </p:nvSpPr>
          <p:spPr>
            <a:xfrm>
              <a:off x="1529196" y="2051855"/>
              <a:ext cx="115278" cy="1587797"/>
            </a:xfrm>
            <a:prstGeom prst="leftBracket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572209" y="1917616"/>
              <a:ext cx="288765" cy="2800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p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594178" y="3498037"/>
              <a:ext cx="270512" cy="2800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c</a:t>
              </a:r>
            </a:p>
          </p:txBody>
        </p:sp>
      </p:grpSp>
      <p:sp>
        <p:nvSpPr>
          <p:cNvPr id="25" name="TextBox 24"/>
          <p:cNvSpPr txBox="1"/>
          <p:nvPr/>
        </p:nvSpPr>
        <p:spPr>
          <a:xfrm>
            <a:off x="6112580" y="3834965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U2AF65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6104935" y="4061657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Tubulin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275084" y="479091"/>
            <a:ext cx="14378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/>
              <a:t>Figure S6D </a:t>
            </a:r>
          </a:p>
        </p:txBody>
      </p:sp>
      <p:grpSp>
        <p:nvGrpSpPr>
          <p:cNvPr id="47" name="Group 46"/>
          <p:cNvGrpSpPr/>
          <p:nvPr/>
        </p:nvGrpSpPr>
        <p:grpSpPr>
          <a:xfrm>
            <a:off x="130720" y="5215660"/>
            <a:ext cx="3399864" cy="2566302"/>
            <a:chOff x="130720" y="4837799"/>
            <a:chExt cx="3399864" cy="2566302"/>
          </a:xfrm>
        </p:grpSpPr>
        <p:pic>
          <p:nvPicPr>
            <p:cNvPr id="45" name="Picture 44"/>
            <p:cNvPicPr>
              <a:picLocks noChangeAspect="1"/>
            </p:cNvPicPr>
            <p:nvPr/>
          </p:nvPicPr>
          <p:blipFill rotWithShape="1">
            <a:blip r:embed="rId4"/>
            <a:srcRect b="9274"/>
            <a:stretch/>
          </p:blipFill>
          <p:spPr>
            <a:xfrm>
              <a:off x="1120836" y="4837799"/>
              <a:ext cx="2409748" cy="2566302"/>
            </a:xfrm>
            <a:prstGeom prst="rect">
              <a:avLst/>
            </a:prstGeom>
          </p:spPr>
        </p:pic>
        <p:grpSp>
          <p:nvGrpSpPr>
            <p:cNvPr id="71" name="Group 70"/>
            <p:cNvGrpSpPr/>
            <p:nvPr/>
          </p:nvGrpSpPr>
          <p:grpSpPr>
            <a:xfrm>
              <a:off x="130720" y="5115664"/>
              <a:ext cx="990116" cy="1805835"/>
              <a:chOff x="737264" y="1917616"/>
              <a:chExt cx="1127426" cy="1860445"/>
            </a:xfrm>
          </p:grpSpPr>
          <p:sp>
            <p:nvSpPr>
              <p:cNvPr id="72" name="TextBox 71"/>
              <p:cNvSpPr txBox="1"/>
              <p:nvPr/>
            </p:nvSpPr>
            <p:spPr>
              <a:xfrm>
                <a:off x="737264" y="2700828"/>
                <a:ext cx="734139" cy="297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SREBP2</a:t>
                </a:r>
                <a:r>
                  <a:rPr lang="en-US" sz="1000" b="1" dirty="0"/>
                  <a:t> </a:t>
                </a:r>
              </a:p>
            </p:txBody>
          </p:sp>
          <p:sp>
            <p:nvSpPr>
              <p:cNvPr id="73" name="Left Bracket 72"/>
              <p:cNvSpPr/>
              <p:nvPr/>
            </p:nvSpPr>
            <p:spPr>
              <a:xfrm>
                <a:off x="1529196" y="2051855"/>
                <a:ext cx="115278" cy="1587797"/>
              </a:xfrm>
              <a:prstGeom prst="leftBracket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1572209" y="1917616"/>
                <a:ext cx="288765" cy="2800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p</a:t>
                </a: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1594178" y="3498037"/>
                <a:ext cx="270512" cy="2800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c</a:t>
                </a:r>
              </a:p>
            </p:txBody>
          </p:sp>
        </p:grpSp>
        <p:sp>
          <p:nvSpPr>
            <p:cNvPr id="76" name="Rectangle 75"/>
            <p:cNvSpPr/>
            <p:nvPr/>
          </p:nvSpPr>
          <p:spPr>
            <a:xfrm>
              <a:off x="1143000" y="4965195"/>
              <a:ext cx="2362184" cy="4093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1072060" y="4918654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FFFF00"/>
                  </a:solidFill>
                </a:rPr>
                <a:t>170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030465" y="5184117"/>
              <a:ext cx="4107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FFFF00"/>
                  </a:solidFill>
                </a:rPr>
                <a:t>130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1030465" y="5851068"/>
              <a:ext cx="4107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FFFF00"/>
                  </a:solidFill>
                </a:rPr>
                <a:t>100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1039234" y="6405468"/>
              <a:ext cx="4107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FFFF00"/>
                  </a:solidFill>
                </a:rPr>
                <a:t>70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1039234" y="6944454"/>
              <a:ext cx="4107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FFFF00"/>
                  </a:solidFill>
                </a:rPr>
                <a:t>55</a:t>
              </a:r>
            </a:p>
          </p:txBody>
        </p:sp>
      </p:grpSp>
      <p:sp>
        <p:nvSpPr>
          <p:cNvPr id="96" name="TextBox 95"/>
          <p:cNvSpPr txBox="1"/>
          <p:nvPr/>
        </p:nvSpPr>
        <p:spPr>
          <a:xfrm>
            <a:off x="1796716" y="4473094"/>
            <a:ext cx="11118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u="sng" dirty="0"/>
              <a:t>Long exposure</a:t>
            </a:r>
            <a:endParaRPr lang="en-US" sz="1200" b="1" u="sng" dirty="0"/>
          </a:p>
        </p:txBody>
      </p:sp>
      <p:sp>
        <p:nvSpPr>
          <p:cNvPr id="97" name="TextBox 96"/>
          <p:cNvSpPr txBox="1"/>
          <p:nvPr/>
        </p:nvSpPr>
        <p:spPr>
          <a:xfrm>
            <a:off x="1825544" y="7818143"/>
            <a:ext cx="1151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u="sng" dirty="0"/>
              <a:t>Short exposure</a:t>
            </a:r>
            <a:endParaRPr lang="en-US" sz="1200" b="1" u="sng" dirty="0"/>
          </a:p>
        </p:txBody>
      </p:sp>
    </p:spTree>
    <p:extLst>
      <p:ext uri="{BB962C8B-B14F-4D97-AF65-F5344CB8AC3E}">
        <p14:creationId xmlns:p14="http://schemas.microsoft.com/office/powerpoint/2010/main" val="9471892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90644" y="455733"/>
            <a:ext cx="14378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/>
              <a:t>Figure S7C 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3844" y="1083369"/>
            <a:ext cx="1941435" cy="300573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961000" y="1105087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100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977264" y="1234143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70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913795" y="1475952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10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933844" y="1605008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7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888744" y="2154705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10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893219" y="2031223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13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896187" y="1942340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17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898888" y="2572207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43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912513" y="2435720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55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922123" y="2915258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17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915489" y="3088666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10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920045" y="2999897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13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934978" y="3470715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55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946699" y="3330838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7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992222" y="3833873"/>
            <a:ext cx="311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solidFill>
                  <a:srgbClr val="FFFF00"/>
                </a:solidFill>
              </a:rPr>
              <a:t>34</a:t>
            </a:r>
          </a:p>
        </p:txBody>
      </p:sp>
      <p:grpSp>
        <p:nvGrpSpPr>
          <p:cNvPr id="19" name="Group 18"/>
          <p:cNvGrpSpPr/>
          <p:nvPr/>
        </p:nvGrpSpPr>
        <p:grpSpPr>
          <a:xfrm>
            <a:off x="1209643" y="882812"/>
            <a:ext cx="2045084" cy="246221"/>
            <a:chOff x="586781" y="5424570"/>
            <a:chExt cx="2045084" cy="246221"/>
          </a:xfrm>
        </p:grpSpPr>
        <p:grpSp>
          <p:nvGrpSpPr>
            <p:cNvPr id="20" name="Group 19"/>
            <p:cNvGrpSpPr/>
            <p:nvPr/>
          </p:nvGrpSpPr>
          <p:grpSpPr>
            <a:xfrm>
              <a:off x="1537825" y="5432298"/>
              <a:ext cx="1094040" cy="211605"/>
              <a:chOff x="2117549" y="1209928"/>
              <a:chExt cx="1094040" cy="211605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2117549" y="1209928"/>
                <a:ext cx="23916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A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332874" y="1214906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B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2578955" y="1215129"/>
                <a:ext cx="23275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C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2778370" y="1221478"/>
                <a:ext cx="24077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D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983641" y="1215128"/>
                <a:ext cx="22794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E</a:t>
                </a:r>
              </a:p>
            </p:txBody>
          </p:sp>
        </p:grpSp>
        <p:sp>
          <p:nvSpPr>
            <p:cNvPr id="21" name="TextBox 20"/>
            <p:cNvSpPr txBox="1"/>
            <p:nvPr/>
          </p:nvSpPr>
          <p:spPr>
            <a:xfrm>
              <a:off x="586781" y="5424570"/>
              <a:ext cx="6912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Fractions</a:t>
              </a:r>
              <a:r>
                <a:rPr lang="en-US" sz="700" b="1" dirty="0"/>
                <a:t> </a:t>
              </a:r>
              <a:endParaRPr lang="en-US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482920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69</TotalTime>
  <Words>391</Words>
  <Application>Microsoft Macintosh PowerPoint</Application>
  <PresentationFormat>A4 Paper (210x297 mm)</PresentationFormat>
  <Paragraphs>331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tyanand Bolshette</dc:creator>
  <cp:lastModifiedBy>Gad Asher</cp:lastModifiedBy>
  <cp:revision>60</cp:revision>
  <dcterms:created xsi:type="dcterms:W3CDTF">2023-07-09T08:57:27Z</dcterms:created>
  <dcterms:modified xsi:type="dcterms:W3CDTF">2023-10-16T11:05:03Z</dcterms:modified>
</cp:coreProperties>
</file>